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drawings/drawing3.xml" ContentType="application/vnd.openxmlformats-officedocument.drawingml.chartshapes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drawings/drawing4.xml" ContentType="application/vnd.openxmlformats-officedocument.drawingml.chartshapes+xml"/>
  <Override PartName="/ppt/charts/chart8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9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5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91" r:id="rId2"/>
    <p:sldId id="290" r:id="rId3"/>
    <p:sldId id="257" r:id="rId4"/>
    <p:sldId id="287" r:id="rId5"/>
    <p:sldId id="283" r:id="rId6"/>
    <p:sldId id="260" r:id="rId7"/>
    <p:sldId id="267" r:id="rId8"/>
    <p:sldId id="281" r:id="rId9"/>
    <p:sldId id="256" r:id="rId10"/>
    <p:sldId id="282" r:id="rId11"/>
    <p:sldId id="285" r:id="rId12"/>
    <p:sldId id="286" r:id="rId13"/>
    <p:sldId id="292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649" autoAdjust="0"/>
    <p:restoredTop sz="95833" autoAdjust="0"/>
  </p:normalViewPr>
  <p:slideViewPr>
    <p:cSldViewPr snapToGrid="0">
      <p:cViewPr varScale="1">
        <p:scale>
          <a:sx n="72" d="100"/>
          <a:sy n="72" d="100"/>
        </p:scale>
        <p:origin x="9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Users\tka2001\Documents\ANKRD12%20_paper-may4\results%20for%20paper\Cytoplasm%20and%20nucleus-data%20sheet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tka2001\Documents\ANKRD12%20_paper-may4\results%20for%20paper\Cytoplasm%20and%20nucleus-data%20sheet.xls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\\Users\tka2001\Dropbox\NFATC3-fatima\skov3%20seahorese\skov3-si-anknfcirclin.xlsm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\\Users\tka2001\Dropbox\NFATC3-fatima\over%20expression-nfat\over%20expression%20nfat%20seahorse-mda-sk\MitoStress_NFATC3_overexpression_SKOV3.xlsm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tka2001\Dropbox\NFATC3-fatima\over%20expression-nfat\over%20expression%20nfat%20seahorse-mda-sk\MitoStress_NFATC3_overexpression_SKOV3.xlsm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AL-DASIM\skov3%20seahorese\energy%20phenotye_NFATC3_1overexpression_SKOV3.xlsm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\\Users\tka2001\Dropbox\NFATC3-fatima\skov3%20seahorese\energy%20phenotye_NFATC3_overexpression_SKOV3.xlsm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hasni\Dropbox\NFATC3-fatima\results-nfat\phenotype%20knockdown-nfatapri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hasni\Dropbox\NFATC3-fatima\results-nfat\phenotype%20knockdown-nfatapril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chemeClr val="tx1"/>
                </a:solidFill>
              </a:rPr>
              <a:t>18s </a:t>
            </a:r>
            <a:r>
              <a:rPr lang="en-US" b="1" err="1">
                <a:solidFill>
                  <a:schemeClr val="tx1"/>
                </a:solidFill>
              </a:rPr>
              <a:t>rRNA</a:t>
            </a:r>
            <a:endParaRPr 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9791691564008299"/>
          <c:y val="0.27156240112571001"/>
          <c:w val="0.63497204587452105"/>
          <c:h val="0.565207594378111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4!$S$44</c:f>
              <c:strCache>
                <c:ptCount val="1"/>
                <c:pt idx="0">
                  <c:v>18srRN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R$45:$R$46</c:f>
              <c:strCache>
                <c:ptCount val="2"/>
                <c:pt idx="0">
                  <c:v>nuclear</c:v>
                </c:pt>
                <c:pt idx="1">
                  <c:v>cytoplasm</c:v>
                </c:pt>
              </c:strCache>
            </c:strRef>
          </c:cat>
          <c:val>
            <c:numRef>
              <c:f>Sheet4!$S$45:$S$46</c:f>
              <c:numCache>
                <c:formatCode>General</c:formatCode>
                <c:ptCount val="2"/>
                <c:pt idx="0">
                  <c:v>1</c:v>
                </c:pt>
                <c:pt idx="1">
                  <c:v>487103.333457171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8B-B144-A8CB-5C75386B94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88477872"/>
        <c:axId val="488480192"/>
      </c:barChart>
      <c:catAx>
        <c:axId val="488477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488480192"/>
        <c:crosses val="autoZero"/>
        <c:auto val="1"/>
        <c:lblAlgn val="ctr"/>
        <c:lblOffset val="100"/>
        <c:noMultiLvlLbl val="0"/>
      </c:catAx>
      <c:valAx>
        <c:axId val="4884801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84778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sz="140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517073732328599"/>
          <c:y val="0.13560723248371401"/>
          <c:w val="0.80482921121908402"/>
          <c:h val="0.700054316127150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4!$W$42</c:f>
              <c:strCache>
                <c:ptCount val="1"/>
                <c:pt idx="0">
                  <c:v>snRNA U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spPr>
              <a:solidFill>
                <a:schemeClr val="accent1"/>
              </a:solidFill>
              <a:ln>
                <a:noFill/>
              </a:ln>
              <a:effectLst/>
            </c:spPr>
          </c:errBars>
          <c:cat>
            <c:strRef>
              <c:f>Sheet4!$V$43:$V$44</c:f>
              <c:strCache>
                <c:ptCount val="2"/>
                <c:pt idx="0">
                  <c:v>nuclear</c:v>
                </c:pt>
                <c:pt idx="1">
                  <c:v>cytoplasm</c:v>
                </c:pt>
              </c:strCache>
            </c:strRef>
          </c:cat>
          <c:val>
            <c:numRef>
              <c:f>Sheet4!$W$43:$W$44</c:f>
              <c:numCache>
                <c:formatCode>General</c:formatCode>
                <c:ptCount val="2"/>
                <c:pt idx="0">
                  <c:v>150.811623660309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22-5847-8110-B79ACC62A1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488378352"/>
        <c:axId val="488380672"/>
      </c:barChart>
      <c:catAx>
        <c:axId val="488378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488380672"/>
        <c:crosses val="autoZero"/>
        <c:auto val="1"/>
        <c:lblAlgn val="ctr"/>
        <c:lblOffset val="100"/>
        <c:noMultiLvlLbl val="0"/>
      </c:catAx>
      <c:valAx>
        <c:axId val="488380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48837835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 lang="en-US"/>
            </a:pPr>
            <a:r>
              <a:rPr lang="en-US"/>
              <a:t>Mitochondrial Respiration</a:t>
            </a: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29979454358726787"/>
          <c:y val="0.11532852055399444"/>
          <c:w val="0.59259368024207548"/>
          <c:h val="0.69126276970443945"/>
        </c:manualLayout>
      </c:layout>
      <c:scatterChart>
        <c:scatterStyle val="lineMarker"/>
        <c:varyColors val="0"/>
        <c:ser>
          <c:idx val="0"/>
          <c:order val="0"/>
          <c:tx>
            <c:strRef>
              <c:f>'Summary Printout'!$AB$103</c:f>
              <c:strCache>
                <c:ptCount val="1"/>
                <c:pt idx="0">
                  <c:v>Group 1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solidFill>
                <a:schemeClr val="accent6">
                  <a:lumMod val="75000"/>
                </a:schemeClr>
              </a:solidFill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N$104:$AN$115</c:f>
                <c:numCache>
                  <c:formatCode>General</c:formatCode>
                  <c:ptCount val="12"/>
                  <c:pt idx="0">
                    <c:v>2.7834307499399871</c:v>
                  </c:pt>
                  <c:pt idx="1">
                    <c:v>2.6121792635981831</c:v>
                  </c:pt>
                  <c:pt idx="2">
                    <c:v>3.3707781170632378</c:v>
                  </c:pt>
                  <c:pt idx="3">
                    <c:v>2.9323676882475409</c:v>
                  </c:pt>
                  <c:pt idx="4">
                    <c:v>2.3567935024994435</c:v>
                  </c:pt>
                  <c:pt idx="5">
                    <c:v>2.4310790993394997</c:v>
                  </c:pt>
                  <c:pt idx="6">
                    <c:v>6.1326442723606931</c:v>
                  </c:pt>
                  <c:pt idx="7">
                    <c:v>8.5611122130891246</c:v>
                  </c:pt>
                  <c:pt idx="8">
                    <c:v>9.588849968864297</c:v>
                  </c:pt>
                  <c:pt idx="9">
                    <c:v>5.1251134207869571</c:v>
                  </c:pt>
                  <c:pt idx="10">
                    <c:v>5.0175124485346183</c:v>
                  </c:pt>
                  <c:pt idx="11">
                    <c:v>5.0729530877604896</c:v>
                  </c:pt>
                </c:numCache>
              </c:numRef>
            </c:plus>
            <c:minus>
              <c:numRef>
                <c:f>'Summary Printout'!$AN$104:$AN$115</c:f>
                <c:numCache>
                  <c:formatCode>General</c:formatCode>
                  <c:ptCount val="12"/>
                  <c:pt idx="0">
                    <c:v>2.7834307499399871</c:v>
                  </c:pt>
                  <c:pt idx="1">
                    <c:v>2.6121792635981831</c:v>
                  </c:pt>
                  <c:pt idx="2">
                    <c:v>3.3707781170632378</c:v>
                  </c:pt>
                  <c:pt idx="3">
                    <c:v>2.9323676882475409</c:v>
                  </c:pt>
                  <c:pt idx="4">
                    <c:v>2.3567935024994435</c:v>
                  </c:pt>
                  <c:pt idx="5">
                    <c:v>2.4310790993394997</c:v>
                  </c:pt>
                  <c:pt idx="6">
                    <c:v>6.1326442723606931</c:v>
                  </c:pt>
                  <c:pt idx="7">
                    <c:v>8.5611122130891246</c:v>
                  </c:pt>
                  <c:pt idx="8">
                    <c:v>9.588849968864297</c:v>
                  </c:pt>
                  <c:pt idx="9">
                    <c:v>5.1251134207869571</c:v>
                  </c:pt>
                  <c:pt idx="10">
                    <c:v>5.0175124485346183</c:v>
                  </c:pt>
                  <c:pt idx="11">
                    <c:v>5.0729530877604896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764260333333</c:v>
                </c:pt>
                <c:pt idx="1">
                  <c:v>7.8090633199999999</c:v>
                </c:pt>
                <c:pt idx="2">
                  <c:v>14.3777056916667</c:v>
                </c:pt>
                <c:pt idx="3">
                  <c:v>20.997000960000001</c:v>
                </c:pt>
                <c:pt idx="4">
                  <c:v>27.557842884999999</c:v>
                </c:pt>
                <c:pt idx="5">
                  <c:v>34.090366525</c:v>
                </c:pt>
                <c:pt idx="6">
                  <c:v>40.713678690000002</c:v>
                </c:pt>
                <c:pt idx="7">
                  <c:v>47.215733918333299</c:v>
                </c:pt>
                <c:pt idx="8">
                  <c:v>53.81722817</c:v>
                </c:pt>
                <c:pt idx="9">
                  <c:v>60.447074041666703</c:v>
                </c:pt>
                <c:pt idx="10">
                  <c:v>66.992165066666701</c:v>
                </c:pt>
                <c:pt idx="11">
                  <c:v>73.529622320000001</c:v>
                </c:pt>
              </c:numCache>
            </c:numRef>
          </c:xVal>
          <c:yVal>
            <c:numRef>
              <c:f>'Summary Printout'!$AB$104:$AB$115</c:f>
              <c:numCache>
                <c:formatCode>0.0</c:formatCode>
                <c:ptCount val="12"/>
                <c:pt idx="0">
                  <c:v>141.98382732126271</c:v>
                </c:pt>
                <c:pt idx="1">
                  <c:v>130.79487454523183</c:v>
                </c:pt>
                <c:pt idx="2">
                  <c:v>128.78014691279029</c:v>
                </c:pt>
                <c:pt idx="3">
                  <c:v>85.692723964907586</c:v>
                </c:pt>
                <c:pt idx="4">
                  <c:v>76.405420894146189</c:v>
                </c:pt>
                <c:pt idx="5">
                  <c:v>74.664641323590004</c:v>
                </c:pt>
                <c:pt idx="6">
                  <c:v>97.973165834627167</c:v>
                </c:pt>
                <c:pt idx="7">
                  <c:v>104.11846594482039</c:v>
                </c:pt>
                <c:pt idx="8">
                  <c:v>108.82753592964013</c:v>
                </c:pt>
                <c:pt idx="9">
                  <c:v>51.563093349626925</c:v>
                </c:pt>
                <c:pt idx="10">
                  <c:v>49.982169969423083</c:v>
                </c:pt>
                <c:pt idx="11">
                  <c:v>48.5003192347941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D42-C24B-BB08-EC008A5F836F}"/>
            </c:ext>
          </c:extLst>
        </c:ser>
        <c:ser>
          <c:idx val="1"/>
          <c:order val="1"/>
          <c:tx>
            <c:strRef>
              <c:f>'Summary Printout'!$AC$103</c:f>
              <c:strCache>
                <c:ptCount val="1"/>
                <c:pt idx="0">
                  <c:v>Group 2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O$104:$AO$115</c:f>
                <c:numCache>
                  <c:formatCode>General</c:formatCode>
                  <c:ptCount val="12"/>
                  <c:pt idx="0">
                    <c:v>0.95718516913423501</c:v>
                  </c:pt>
                  <c:pt idx="1">
                    <c:v>1.0648780681245913</c:v>
                  </c:pt>
                  <c:pt idx="2">
                    <c:v>1.2576803032915183</c:v>
                  </c:pt>
                  <c:pt idx="3">
                    <c:v>0.91740296930349763</c:v>
                  </c:pt>
                  <c:pt idx="4">
                    <c:v>1.2023712740215642</c:v>
                  </c:pt>
                  <c:pt idx="5">
                    <c:v>1.2088010604252453</c:v>
                  </c:pt>
                  <c:pt idx="6">
                    <c:v>2.6197934416855051</c:v>
                  </c:pt>
                  <c:pt idx="7">
                    <c:v>3.1689675985285053</c:v>
                  </c:pt>
                  <c:pt idx="8">
                    <c:v>3.6213771952757687</c:v>
                  </c:pt>
                  <c:pt idx="9">
                    <c:v>4.7555842116650258</c:v>
                  </c:pt>
                  <c:pt idx="10">
                    <c:v>4.8498663707822951</c:v>
                  </c:pt>
                  <c:pt idx="11">
                    <c:v>5.0249164901819965</c:v>
                  </c:pt>
                </c:numCache>
              </c:numRef>
            </c:plus>
            <c:minus>
              <c:numRef>
                <c:f>'Summary Printout'!$AO$104:$AO$115</c:f>
                <c:numCache>
                  <c:formatCode>General</c:formatCode>
                  <c:ptCount val="12"/>
                  <c:pt idx="0">
                    <c:v>0.95718516913423501</c:v>
                  </c:pt>
                  <c:pt idx="1">
                    <c:v>1.0648780681245913</c:v>
                  </c:pt>
                  <c:pt idx="2">
                    <c:v>1.2576803032915183</c:v>
                  </c:pt>
                  <c:pt idx="3">
                    <c:v>0.91740296930349763</c:v>
                  </c:pt>
                  <c:pt idx="4">
                    <c:v>1.2023712740215642</c:v>
                  </c:pt>
                  <c:pt idx="5">
                    <c:v>1.2088010604252453</c:v>
                  </c:pt>
                  <c:pt idx="6">
                    <c:v>2.6197934416855051</c:v>
                  </c:pt>
                  <c:pt idx="7">
                    <c:v>3.1689675985285053</c:v>
                  </c:pt>
                  <c:pt idx="8">
                    <c:v>3.6213771952757687</c:v>
                  </c:pt>
                  <c:pt idx="9">
                    <c:v>4.7555842116650258</c:v>
                  </c:pt>
                  <c:pt idx="10">
                    <c:v>4.8498663707822951</c:v>
                  </c:pt>
                  <c:pt idx="11">
                    <c:v>5.0249164901819965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764260333333</c:v>
                </c:pt>
                <c:pt idx="1">
                  <c:v>7.8090633199999999</c:v>
                </c:pt>
                <c:pt idx="2">
                  <c:v>14.3777056916667</c:v>
                </c:pt>
                <c:pt idx="3">
                  <c:v>20.997000960000001</c:v>
                </c:pt>
                <c:pt idx="4">
                  <c:v>27.557842884999999</c:v>
                </c:pt>
                <c:pt idx="5">
                  <c:v>34.090366525</c:v>
                </c:pt>
                <c:pt idx="6">
                  <c:v>40.713678690000002</c:v>
                </c:pt>
                <c:pt idx="7">
                  <c:v>47.215733918333299</c:v>
                </c:pt>
                <c:pt idx="8">
                  <c:v>53.81722817</c:v>
                </c:pt>
                <c:pt idx="9">
                  <c:v>60.447074041666703</c:v>
                </c:pt>
                <c:pt idx="10">
                  <c:v>66.992165066666701</c:v>
                </c:pt>
                <c:pt idx="11">
                  <c:v>73.529622320000001</c:v>
                </c:pt>
              </c:numCache>
            </c:numRef>
          </c:xVal>
          <c:yVal>
            <c:numRef>
              <c:f>'Summary Printout'!$AC$104:$AC$115</c:f>
              <c:numCache>
                <c:formatCode>0.0</c:formatCode>
                <c:ptCount val="12"/>
                <c:pt idx="0">
                  <c:v>128.36868180546418</c:v>
                </c:pt>
                <c:pt idx="1">
                  <c:v>119.12372180835364</c:v>
                </c:pt>
                <c:pt idx="2">
                  <c:v>115.5609944880007</c:v>
                </c:pt>
                <c:pt idx="3">
                  <c:v>78.743543952564551</c:v>
                </c:pt>
                <c:pt idx="4">
                  <c:v>71.502429074615122</c:v>
                </c:pt>
                <c:pt idx="5">
                  <c:v>69.862032546563213</c:v>
                </c:pt>
                <c:pt idx="6">
                  <c:v>79.271822332314542</c:v>
                </c:pt>
                <c:pt idx="7">
                  <c:v>82.232576217244386</c:v>
                </c:pt>
                <c:pt idx="8">
                  <c:v>85.41507051113058</c:v>
                </c:pt>
                <c:pt idx="9">
                  <c:v>52.592864660211539</c:v>
                </c:pt>
                <c:pt idx="10">
                  <c:v>51.098712098894929</c:v>
                </c:pt>
                <c:pt idx="11">
                  <c:v>49.9156883480763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D42-C24B-BB08-EC008A5F836F}"/>
            </c:ext>
          </c:extLst>
        </c:ser>
        <c:ser>
          <c:idx val="2"/>
          <c:order val="2"/>
          <c:tx>
            <c:strRef>
              <c:f>'Summary Printout'!$AD$103</c:f>
              <c:strCache>
                <c:ptCount val="1"/>
                <c:pt idx="0">
                  <c:v>Group 3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solidFill>
                <a:srgbClr val="C00000"/>
              </a:solidFill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P$104:$AP$115</c:f>
                <c:numCache>
                  <c:formatCode>General</c:formatCode>
                  <c:ptCount val="12"/>
                  <c:pt idx="0">
                    <c:v>1.7223365663691417</c:v>
                  </c:pt>
                  <c:pt idx="1">
                    <c:v>1.7803101949628568</c:v>
                  </c:pt>
                  <c:pt idx="2">
                    <c:v>1.7229465466623668</c:v>
                  </c:pt>
                  <c:pt idx="3">
                    <c:v>0.96500539277525199</c:v>
                  </c:pt>
                  <c:pt idx="4">
                    <c:v>1.2098932133173161</c:v>
                  </c:pt>
                  <c:pt idx="5">
                    <c:v>1.114107703448038</c:v>
                  </c:pt>
                  <c:pt idx="6">
                    <c:v>3.250399199078835</c:v>
                  </c:pt>
                  <c:pt idx="7">
                    <c:v>4.6154542592533581</c:v>
                  </c:pt>
                  <c:pt idx="8">
                    <c:v>4.7279514295465992</c:v>
                  </c:pt>
                  <c:pt idx="9">
                    <c:v>3.8423399739977748</c:v>
                  </c:pt>
                  <c:pt idx="10">
                    <c:v>3.8767243031474381</c:v>
                  </c:pt>
                  <c:pt idx="11">
                    <c:v>3.8082142496745739</c:v>
                  </c:pt>
                </c:numCache>
              </c:numRef>
            </c:plus>
            <c:minus>
              <c:numRef>
                <c:f>'Summary Printout'!$AP$104:$AP$115</c:f>
                <c:numCache>
                  <c:formatCode>General</c:formatCode>
                  <c:ptCount val="12"/>
                  <c:pt idx="0">
                    <c:v>1.7223365663691417</c:v>
                  </c:pt>
                  <c:pt idx="1">
                    <c:v>1.7803101949628568</c:v>
                  </c:pt>
                  <c:pt idx="2">
                    <c:v>1.7229465466623668</c:v>
                  </c:pt>
                  <c:pt idx="3">
                    <c:v>0.96500539277525199</c:v>
                  </c:pt>
                  <c:pt idx="4">
                    <c:v>1.2098932133173161</c:v>
                  </c:pt>
                  <c:pt idx="5">
                    <c:v>1.114107703448038</c:v>
                  </c:pt>
                  <c:pt idx="6">
                    <c:v>3.250399199078835</c:v>
                  </c:pt>
                  <c:pt idx="7">
                    <c:v>4.6154542592533581</c:v>
                  </c:pt>
                  <c:pt idx="8">
                    <c:v>4.7279514295465992</c:v>
                  </c:pt>
                  <c:pt idx="9">
                    <c:v>3.8423399739977748</c:v>
                  </c:pt>
                  <c:pt idx="10">
                    <c:v>3.8767243031474381</c:v>
                  </c:pt>
                  <c:pt idx="11">
                    <c:v>3.8082142496745739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764260333333</c:v>
                </c:pt>
                <c:pt idx="1">
                  <c:v>7.8090633199999999</c:v>
                </c:pt>
                <c:pt idx="2">
                  <c:v>14.3777056916667</c:v>
                </c:pt>
                <c:pt idx="3">
                  <c:v>20.997000960000001</c:v>
                </c:pt>
                <c:pt idx="4">
                  <c:v>27.557842884999999</c:v>
                </c:pt>
                <c:pt idx="5">
                  <c:v>34.090366525</c:v>
                </c:pt>
                <c:pt idx="6">
                  <c:v>40.713678690000002</c:v>
                </c:pt>
                <c:pt idx="7">
                  <c:v>47.215733918333299</c:v>
                </c:pt>
                <c:pt idx="8">
                  <c:v>53.81722817</c:v>
                </c:pt>
                <c:pt idx="9">
                  <c:v>60.447074041666703</c:v>
                </c:pt>
                <c:pt idx="10">
                  <c:v>66.992165066666701</c:v>
                </c:pt>
                <c:pt idx="11">
                  <c:v>73.529622320000001</c:v>
                </c:pt>
              </c:numCache>
            </c:numRef>
          </c:xVal>
          <c:yVal>
            <c:numRef>
              <c:f>'Summary Printout'!$AD$104:$AD$115</c:f>
              <c:numCache>
                <c:formatCode>0.0</c:formatCode>
                <c:ptCount val="12"/>
                <c:pt idx="0">
                  <c:v>127.7593653759124</c:v>
                </c:pt>
                <c:pt idx="1">
                  <c:v>118.53533367501988</c:v>
                </c:pt>
                <c:pt idx="2">
                  <c:v>115.18037994467871</c:v>
                </c:pt>
                <c:pt idx="3">
                  <c:v>79.487219654097302</c:v>
                </c:pt>
                <c:pt idx="4">
                  <c:v>71.608146033031218</c:v>
                </c:pt>
                <c:pt idx="5">
                  <c:v>69.80472513656585</c:v>
                </c:pt>
                <c:pt idx="6">
                  <c:v>75.828507130203121</c:v>
                </c:pt>
                <c:pt idx="7">
                  <c:v>81.195519992752367</c:v>
                </c:pt>
                <c:pt idx="8">
                  <c:v>83.433971386949409</c:v>
                </c:pt>
                <c:pt idx="9">
                  <c:v>48.680378040042903</c:v>
                </c:pt>
                <c:pt idx="10">
                  <c:v>47.403526706558658</c:v>
                </c:pt>
                <c:pt idx="11">
                  <c:v>46.6939601888445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D42-C24B-BB08-EC008A5F836F}"/>
            </c:ext>
          </c:extLst>
        </c:ser>
        <c:ser>
          <c:idx val="3"/>
          <c:order val="3"/>
          <c:tx>
            <c:strRef>
              <c:f>'Summary Printout'!$AE$103</c:f>
              <c:strCache>
                <c:ptCount val="1"/>
                <c:pt idx="0">
                  <c:v>Unselected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Summary Printout'!$AQ$104:$AQ$115</c:f>
              </c:numRef>
            </c:plus>
            <c:minus>
              <c:numRef>
                <c:f>'Summary Printout'!$AQ$104:$AQ$115</c:f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764260333333</c:v>
                </c:pt>
                <c:pt idx="1">
                  <c:v>7.8090633199999999</c:v>
                </c:pt>
                <c:pt idx="2">
                  <c:v>14.3777056916667</c:v>
                </c:pt>
                <c:pt idx="3">
                  <c:v>20.997000960000001</c:v>
                </c:pt>
                <c:pt idx="4">
                  <c:v>27.557842884999999</c:v>
                </c:pt>
                <c:pt idx="5">
                  <c:v>34.090366525</c:v>
                </c:pt>
                <c:pt idx="6">
                  <c:v>40.713678690000002</c:v>
                </c:pt>
                <c:pt idx="7">
                  <c:v>47.215733918333299</c:v>
                </c:pt>
                <c:pt idx="8">
                  <c:v>53.81722817</c:v>
                </c:pt>
                <c:pt idx="9">
                  <c:v>60.447074041666703</c:v>
                </c:pt>
                <c:pt idx="10">
                  <c:v>66.992165066666701</c:v>
                </c:pt>
                <c:pt idx="11">
                  <c:v>73.529622320000001</c:v>
                </c:pt>
              </c:numCache>
            </c:numRef>
          </c:xVal>
          <c:yVal>
            <c:numRef>
              <c:f>'Summary Printout'!$AE$104:$AE$115</c:f>
            </c:numRef>
          </c:yVal>
          <c:smooth val="0"/>
          <c:extLst>
            <c:ext xmlns:c16="http://schemas.microsoft.com/office/drawing/2014/chart" uri="{C3380CC4-5D6E-409C-BE32-E72D297353CC}">
              <c16:uniqueId val="{00000003-CD42-C24B-BB08-EC008A5F83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815872"/>
        <c:axId val="192818176"/>
      </c:scatterChart>
      <c:valAx>
        <c:axId val="192815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Time (min)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US" sz="1100"/>
            </a:pPr>
            <a:endParaRPr lang="en-US"/>
          </a:p>
        </c:txPr>
        <c:crossAx val="192818176"/>
        <c:crosses val="autoZero"/>
        <c:crossBetween val="midCat"/>
      </c:valAx>
      <c:valAx>
        <c:axId val="1928181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OCR (pmol/min)</a:t>
                </a:r>
              </a:p>
            </c:rich>
          </c:tx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US" sz="1100"/>
            </a:pPr>
            <a:endParaRPr lang="en-US"/>
          </a:p>
        </c:txPr>
        <c:crossAx val="192815872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/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400" dirty="0"/>
              <a:t>Mitochondrial Respiration</a:t>
            </a:r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0295501551562332"/>
          <c:y val="2.6119318234395013E-2"/>
          <c:w val="0.85906509891500471"/>
          <c:h val="0.88926033821330253"/>
        </c:manualLayout>
      </c:layout>
      <c:scatterChart>
        <c:scatterStyle val="lineMarker"/>
        <c:varyColors val="0"/>
        <c:ser>
          <c:idx val="0"/>
          <c:order val="0"/>
          <c:tx>
            <c:strRef>
              <c:f>'Summary Printout'!$AB$103</c:f>
              <c:strCache>
                <c:ptCount val="1"/>
                <c:pt idx="0">
                  <c:v>Group 1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solidFill>
                <a:schemeClr val="accent1"/>
              </a:solidFill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R$104:$AR$115</c:f>
                <c:numCache>
                  <c:formatCode>General</c:formatCode>
                  <c:ptCount val="12"/>
                  <c:pt idx="0">
                    <c:v>3.0472599982995621</c:v>
                  </c:pt>
                  <c:pt idx="1">
                    <c:v>2.6354788454018463</c:v>
                  </c:pt>
                  <c:pt idx="2">
                    <c:v>2.5581139552800005</c:v>
                  </c:pt>
                  <c:pt idx="3">
                    <c:v>2.1242162218193248</c:v>
                  </c:pt>
                  <c:pt idx="4">
                    <c:v>2.192154243668885</c:v>
                  </c:pt>
                  <c:pt idx="5">
                    <c:v>2.1052422857267459</c:v>
                  </c:pt>
                  <c:pt idx="6">
                    <c:v>2.7149295686261383</c:v>
                  </c:pt>
                  <c:pt idx="7">
                    <c:v>2.8480932326864568</c:v>
                  </c:pt>
                  <c:pt idx="8">
                    <c:v>2.8700611279778463</c:v>
                  </c:pt>
                  <c:pt idx="9">
                    <c:v>1.3201407412207029</c:v>
                  </c:pt>
                  <c:pt idx="10">
                    <c:v>1.2772496757744605</c:v>
                  </c:pt>
                  <c:pt idx="11">
                    <c:v>1.235822363141714</c:v>
                  </c:pt>
                </c:numCache>
              </c:numRef>
            </c:plus>
            <c:minus>
              <c:numRef>
                <c:f>'Summary Printout'!$AR$104:$AR$115</c:f>
                <c:numCache>
                  <c:formatCode>General</c:formatCode>
                  <c:ptCount val="12"/>
                  <c:pt idx="0">
                    <c:v>3.0472599982995621</c:v>
                  </c:pt>
                  <c:pt idx="1">
                    <c:v>2.6354788454018463</c:v>
                  </c:pt>
                  <c:pt idx="2">
                    <c:v>2.5581139552800005</c:v>
                  </c:pt>
                  <c:pt idx="3">
                    <c:v>2.1242162218193248</c:v>
                  </c:pt>
                  <c:pt idx="4">
                    <c:v>2.192154243668885</c:v>
                  </c:pt>
                  <c:pt idx="5">
                    <c:v>2.1052422857267459</c:v>
                  </c:pt>
                  <c:pt idx="6">
                    <c:v>2.7149295686261383</c:v>
                  </c:pt>
                  <c:pt idx="7">
                    <c:v>2.8480932326864568</c:v>
                  </c:pt>
                  <c:pt idx="8">
                    <c:v>2.8700611279778463</c:v>
                  </c:pt>
                  <c:pt idx="9">
                    <c:v>1.3201407412207029</c:v>
                  </c:pt>
                  <c:pt idx="10">
                    <c:v>1.2772496757744605</c:v>
                  </c:pt>
                  <c:pt idx="11">
                    <c:v>1.235822363141714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B$104:$AB$115</c:f>
              <c:numCache>
                <c:formatCode>0.0</c:formatCode>
                <c:ptCount val="12"/>
                <c:pt idx="0">
                  <c:v>76.294401887855415</c:v>
                </c:pt>
                <c:pt idx="1">
                  <c:v>70.16343455211063</c:v>
                </c:pt>
                <c:pt idx="2">
                  <c:v>68.688810545327314</c:v>
                </c:pt>
                <c:pt idx="3">
                  <c:v>56.748214371152962</c:v>
                </c:pt>
                <c:pt idx="4">
                  <c:v>56.395216501665644</c:v>
                </c:pt>
                <c:pt idx="5">
                  <c:v>55.146657583777333</c:v>
                </c:pt>
                <c:pt idx="6">
                  <c:v>63.908037815606818</c:v>
                </c:pt>
                <c:pt idx="7">
                  <c:v>64.306091069379647</c:v>
                </c:pt>
                <c:pt idx="8">
                  <c:v>63.445513939504735</c:v>
                </c:pt>
                <c:pt idx="9">
                  <c:v>38.487683384647369</c:v>
                </c:pt>
                <c:pt idx="10">
                  <c:v>37.729022976837861</c:v>
                </c:pt>
                <c:pt idx="11">
                  <c:v>37.04469634259105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0D1-1E42-AF6E-548BAA551D33}"/>
            </c:ext>
          </c:extLst>
        </c:ser>
        <c:ser>
          <c:idx val="1"/>
          <c:order val="1"/>
          <c:tx>
            <c:strRef>
              <c:f>'Summary Printout'!$AC$103</c:f>
              <c:strCache>
                <c:ptCount val="1"/>
                <c:pt idx="0">
                  <c:v>Group 2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S$104:$AS$115</c:f>
                <c:numCache>
                  <c:formatCode>General</c:formatCode>
                  <c:ptCount val="12"/>
                  <c:pt idx="0">
                    <c:v>3.296543579281046</c:v>
                  </c:pt>
                  <c:pt idx="1">
                    <c:v>3.1053843930827778</c:v>
                  </c:pt>
                  <c:pt idx="2">
                    <c:v>3.0696113518271355</c:v>
                  </c:pt>
                  <c:pt idx="3">
                    <c:v>2.814615689759234</c:v>
                  </c:pt>
                  <c:pt idx="4">
                    <c:v>2.7798489915699096</c:v>
                  </c:pt>
                  <c:pt idx="5">
                    <c:v>2.7808209007180444</c:v>
                  </c:pt>
                  <c:pt idx="6">
                    <c:v>3.2516875664218619</c:v>
                  </c:pt>
                  <c:pt idx="7">
                    <c:v>3.2940028824795728</c:v>
                  </c:pt>
                  <c:pt idx="8">
                    <c:v>3.3505679069230867</c:v>
                  </c:pt>
                  <c:pt idx="9">
                    <c:v>2.6319769815962499</c:v>
                  </c:pt>
                  <c:pt idx="10">
                    <c:v>2.5486031442409574</c:v>
                  </c:pt>
                  <c:pt idx="11">
                    <c:v>2.5424218172965083</c:v>
                  </c:pt>
                </c:numCache>
              </c:numRef>
            </c:plus>
            <c:minus>
              <c:numRef>
                <c:f>'Summary Printout'!$AS$104:$AS$115</c:f>
                <c:numCache>
                  <c:formatCode>General</c:formatCode>
                  <c:ptCount val="12"/>
                  <c:pt idx="0">
                    <c:v>3.296543579281046</c:v>
                  </c:pt>
                  <c:pt idx="1">
                    <c:v>3.1053843930827778</c:v>
                  </c:pt>
                  <c:pt idx="2">
                    <c:v>3.0696113518271355</c:v>
                  </c:pt>
                  <c:pt idx="3">
                    <c:v>2.814615689759234</c:v>
                  </c:pt>
                  <c:pt idx="4">
                    <c:v>2.7798489915699096</c:v>
                  </c:pt>
                  <c:pt idx="5">
                    <c:v>2.7808209007180444</c:v>
                  </c:pt>
                  <c:pt idx="6">
                    <c:v>3.2516875664218619</c:v>
                  </c:pt>
                  <c:pt idx="7">
                    <c:v>3.2940028824795728</c:v>
                  </c:pt>
                  <c:pt idx="8">
                    <c:v>3.3505679069230867</c:v>
                  </c:pt>
                  <c:pt idx="9">
                    <c:v>2.6319769815962499</c:v>
                  </c:pt>
                  <c:pt idx="10">
                    <c:v>2.5486031442409574</c:v>
                  </c:pt>
                  <c:pt idx="11">
                    <c:v>2.5424218172965083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C$104:$AC$115</c:f>
              <c:numCache>
                <c:formatCode>0.0</c:formatCode>
                <c:ptCount val="12"/>
                <c:pt idx="0">
                  <c:v>87.886190572523731</c:v>
                </c:pt>
                <c:pt idx="1">
                  <c:v>81.009901670183936</c:v>
                </c:pt>
                <c:pt idx="2">
                  <c:v>79.09995093627289</c:v>
                </c:pt>
                <c:pt idx="3">
                  <c:v>64.891359298631187</c:v>
                </c:pt>
                <c:pt idx="4">
                  <c:v>64.097920451917574</c:v>
                </c:pt>
                <c:pt idx="5">
                  <c:v>62.99110996285544</c:v>
                </c:pt>
                <c:pt idx="6">
                  <c:v>73.789606889128962</c:v>
                </c:pt>
                <c:pt idx="7">
                  <c:v>73.774849857350588</c:v>
                </c:pt>
                <c:pt idx="8">
                  <c:v>72.579543391219303</c:v>
                </c:pt>
                <c:pt idx="9">
                  <c:v>41.994977597697542</c:v>
                </c:pt>
                <c:pt idx="10">
                  <c:v>40.89994925117626</c:v>
                </c:pt>
                <c:pt idx="11">
                  <c:v>40.1429971008501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0D1-1E42-AF6E-548BAA551D33}"/>
            </c:ext>
          </c:extLst>
        </c:ser>
        <c:ser>
          <c:idx val="2"/>
          <c:order val="2"/>
          <c:tx>
            <c:strRef>
              <c:f>'Summary Printout'!$AD$103</c:f>
              <c:strCache>
                <c:ptCount val="1"/>
                <c:pt idx="0">
                  <c:v>Group 3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T$104:$AT$115</c:f>
                <c:numCache>
                  <c:formatCode>General</c:formatCode>
                  <c:ptCount val="12"/>
                  <c:pt idx="0">
                    <c:v>2.0561512599948073</c:v>
                  </c:pt>
                  <c:pt idx="1">
                    <c:v>1.7902910239109204</c:v>
                  </c:pt>
                  <c:pt idx="2">
                    <c:v>1.7499558361406775</c:v>
                  </c:pt>
                  <c:pt idx="3">
                    <c:v>1.3279493524690837</c:v>
                  </c:pt>
                  <c:pt idx="4">
                    <c:v>1.2885322316639569</c:v>
                  </c:pt>
                  <c:pt idx="5">
                    <c:v>1.2592192820125547</c:v>
                  </c:pt>
                  <c:pt idx="6">
                    <c:v>2.0252010999995598</c:v>
                  </c:pt>
                  <c:pt idx="7">
                    <c:v>2.1011601962020898</c:v>
                  </c:pt>
                  <c:pt idx="8">
                    <c:v>2.0607071817804075</c:v>
                  </c:pt>
                  <c:pt idx="9">
                    <c:v>0.87055174775936506</c:v>
                  </c:pt>
                  <c:pt idx="10">
                    <c:v>0.87216445643298501</c:v>
                  </c:pt>
                  <c:pt idx="11">
                    <c:v>0.90811590215330884</c:v>
                  </c:pt>
                </c:numCache>
              </c:numRef>
            </c:plus>
            <c:minus>
              <c:numRef>
                <c:f>'Summary Printout'!$AT$104:$AT$115</c:f>
                <c:numCache>
                  <c:formatCode>General</c:formatCode>
                  <c:ptCount val="12"/>
                  <c:pt idx="0">
                    <c:v>2.0561512599948073</c:v>
                  </c:pt>
                  <c:pt idx="1">
                    <c:v>1.7902910239109204</c:v>
                  </c:pt>
                  <c:pt idx="2">
                    <c:v>1.7499558361406775</c:v>
                  </c:pt>
                  <c:pt idx="3">
                    <c:v>1.3279493524690837</c:v>
                  </c:pt>
                  <c:pt idx="4">
                    <c:v>1.2885322316639569</c:v>
                  </c:pt>
                  <c:pt idx="5">
                    <c:v>1.2592192820125547</c:v>
                  </c:pt>
                  <c:pt idx="6">
                    <c:v>2.0252010999995598</c:v>
                  </c:pt>
                  <c:pt idx="7">
                    <c:v>2.1011601962020898</c:v>
                  </c:pt>
                  <c:pt idx="8">
                    <c:v>2.0607071817804075</c:v>
                  </c:pt>
                  <c:pt idx="9">
                    <c:v>0.87055174775936506</c:v>
                  </c:pt>
                  <c:pt idx="10">
                    <c:v>0.87216445643298501</c:v>
                  </c:pt>
                  <c:pt idx="11">
                    <c:v>0.90811590215330884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D$104:$AD$115</c:f>
              <c:numCache>
                <c:formatCode>0.0</c:formatCode>
                <c:ptCount val="12"/>
                <c:pt idx="0">
                  <c:v>69.555461235021411</c:v>
                </c:pt>
                <c:pt idx="1">
                  <c:v>63.904221798881309</c:v>
                </c:pt>
                <c:pt idx="2">
                  <c:v>62.201387001290954</c:v>
                </c:pt>
                <c:pt idx="3">
                  <c:v>51.912096578099749</c:v>
                </c:pt>
                <c:pt idx="4">
                  <c:v>51.111307024683228</c:v>
                </c:pt>
                <c:pt idx="5">
                  <c:v>50.082322738043267</c:v>
                </c:pt>
                <c:pt idx="6">
                  <c:v>58.314120148493572</c:v>
                </c:pt>
                <c:pt idx="7">
                  <c:v>57.783927635600584</c:v>
                </c:pt>
                <c:pt idx="8">
                  <c:v>56.663664897907438</c:v>
                </c:pt>
                <c:pt idx="9">
                  <c:v>36.302405201701966</c:v>
                </c:pt>
                <c:pt idx="10">
                  <c:v>34.810713672839732</c:v>
                </c:pt>
                <c:pt idx="11">
                  <c:v>34.2287094347481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0D1-1E42-AF6E-548BAA551D33}"/>
            </c:ext>
          </c:extLst>
        </c:ser>
        <c:ser>
          <c:idx val="3"/>
          <c:order val="3"/>
          <c:tx>
            <c:strRef>
              <c:f>'Summary Printout'!$AE$103</c:f>
              <c:strCache>
                <c:ptCount val="1"/>
                <c:pt idx="0">
                  <c:v>Group 4</c:v>
                </c:pt>
              </c:strCache>
            </c:strRef>
          </c:tx>
          <c:spPr>
            <a:ln w="15875"/>
            <a:effectLst>
              <a:outerShdw blurRad="63500" dist="37357" dir="2700000" rotWithShape="0">
                <a:scrgbClr r="0" g="0" b="0">
                  <a:alpha val="0"/>
                </a:scrgbClr>
              </a:outerShdw>
            </a:effectLst>
          </c:spPr>
          <c:marker>
            <c:symbol val="circle"/>
            <c:size val="10"/>
            <c:spPr>
              <a:ln w="25400">
                <a:noFill/>
              </a:ln>
              <a:effectLst>
                <a:outerShdw blurRad="63500" dist="37357" dir="2700000" rotWithShape="0">
                  <a:scrgbClr r="0" g="0" b="0">
                    <a:alpha val="0"/>
                  </a:scrgbClr>
                </a:outerShdw>
              </a:effectLst>
              <a:scene3d>
                <a:camera prst="orthographicFront"/>
                <a:lightRig rig="threePt" dir="t"/>
              </a:scene3d>
              <a:sp3d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ummary Printout'!$AU$104:$AU$115</c:f>
                <c:numCache>
                  <c:formatCode>General</c:formatCode>
                  <c:ptCount val="12"/>
                  <c:pt idx="0">
                    <c:v>1.7724146598964523</c:v>
                  </c:pt>
                  <c:pt idx="1">
                    <c:v>1.7226828222783317</c:v>
                  </c:pt>
                  <c:pt idx="2">
                    <c:v>1.6583834419301</c:v>
                  </c:pt>
                  <c:pt idx="3">
                    <c:v>1.1331853646682055</c:v>
                  </c:pt>
                  <c:pt idx="4">
                    <c:v>1.1770541415648652</c:v>
                  </c:pt>
                  <c:pt idx="5">
                    <c:v>1.1697442004345928</c:v>
                  </c:pt>
                  <c:pt idx="6">
                    <c:v>2.226143548765215</c:v>
                  </c:pt>
                  <c:pt idx="7">
                    <c:v>2.2019103439961825</c:v>
                  </c:pt>
                  <c:pt idx="8">
                    <c:v>2.2001653823451752</c:v>
                  </c:pt>
                  <c:pt idx="9">
                    <c:v>0.851239980526456</c:v>
                  </c:pt>
                  <c:pt idx="10">
                    <c:v>0.91422309641547528</c:v>
                  </c:pt>
                  <c:pt idx="11">
                    <c:v>0.93142361077485614</c:v>
                  </c:pt>
                </c:numCache>
              </c:numRef>
            </c:plus>
            <c:minus>
              <c:numRef>
                <c:f>'Summary Printout'!$AU$104:$AU$115</c:f>
                <c:numCache>
                  <c:formatCode>General</c:formatCode>
                  <c:ptCount val="12"/>
                  <c:pt idx="0">
                    <c:v>1.7724146598964523</c:v>
                  </c:pt>
                  <c:pt idx="1">
                    <c:v>1.7226828222783317</c:v>
                  </c:pt>
                  <c:pt idx="2">
                    <c:v>1.6583834419301</c:v>
                  </c:pt>
                  <c:pt idx="3">
                    <c:v>1.1331853646682055</c:v>
                  </c:pt>
                  <c:pt idx="4">
                    <c:v>1.1770541415648652</c:v>
                  </c:pt>
                  <c:pt idx="5">
                    <c:v>1.1697442004345928</c:v>
                  </c:pt>
                  <c:pt idx="6">
                    <c:v>2.226143548765215</c:v>
                  </c:pt>
                  <c:pt idx="7">
                    <c:v>2.2019103439961825</c:v>
                  </c:pt>
                  <c:pt idx="8">
                    <c:v>2.2001653823451752</c:v>
                  </c:pt>
                  <c:pt idx="9">
                    <c:v>0.851239980526456</c:v>
                  </c:pt>
                  <c:pt idx="10">
                    <c:v>0.91422309641547528</c:v>
                  </c:pt>
                  <c:pt idx="11">
                    <c:v>0.93142361077485614</c:v>
                  </c:pt>
                </c:numCache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E$104:$AE$115</c:f>
              <c:numCache>
                <c:formatCode>0.0</c:formatCode>
                <c:ptCount val="12"/>
                <c:pt idx="0">
                  <c:v>54.740502909261401</c:v>
                </c:pt>
                <c:pt idx="1">
                  <c:v>50.910464820048965</c:v>
                </c:pt>
                <c:pt idx="2">
                  <c:v>50.091675616788358</c:v>
                </c:pt>
                <c:pt idx="3">
                  <c:v>42.788674952861385</c:v>
                </c:pt>
                <c:pt idx="4">
                  <c:v>42.341930295535093</c:v>
                </c:pt>
                <c:pt idx="5">
                  <c:v>41.413376118260004</c:v>
                </c:pt>
                <c:pt idx="6">
                  <c:v>47.84313053708658</c:v>
                </c:pt>
                <c:pt idx="7">
                  <c:v>46.754869449035546</c:v>
                </c:pt>
                <c:pt idx="8">
                  <c:v>45.955000451029576</c:v>
                </c:pt>
                <c:pt idx="9">
                  <c:v>30.03531527953448</c:v>
                </c:pt>
                <c:pt idx="10">
                  <c:v>29.192492732374017</c:v>
                </c:pt>
                <c:pt idx="11">
                  <c:v>28.3865972465483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0D1-1E42-AF6E-548BAA551D33}"/>
            </c:ext>
          </c:extLst>
        </c:ser>
        <c:ser>
          <c:idx val="4"/>
          <c:order val="4"/>
          <c:tx>
            <c:strRef>
              <c:f>'Summary Printout'!$AF$103</c:f>
              <c:strCache>
                <c:ptCount val="1"/>
                <c:pt idx="0">
                  <c:v>Group 5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Summary Printout'!$AV$104:$AV$115</c:f>
              </c:numRef>
            </c:plus>
            <c:minus>
              <c:numRef>
                <c:f>'Summary Printout'!$AV$104:$AV$115</c:f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F$104:$AF$115</c:f>
            </c:numRef>
          </c:yVal>
          <c:smooth val="0"/>
          <c:extLst>
            <c:ext xmlns:c16="http://schemas.microsoft.com/office/drawing/2014/chart" uri="{C3380CC4-5D6E-409C-BE32-E72D297353CC}">
              <c16:uniqueId val="{00000004-30D1-1E42-AF6E-548BAA551D33}"/>
            </c:ext>
          </c:extLst>
        </c:ser>
        <c:ser>
          <c:idx val="5"/>
          <c:order val="5"/>
          <c:tx>
            <c:strRef>
              <c:f>'Summary Printout'!$AG$103</c:f>
              <c:strCache>
                <c:ptCount val="1"/>
                <c:pt idx="0">
                  <c:v>Unselected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Summary Printout'!$AW$104:$AW$1048576</c:f>
              </c:numRef>
            </c:plus>
            <c:minus>
              <c:numRef>
                <c:f>'Summary Printout'!$AW$104:$AW$1048576</c:f>
              </c:numRef>
            </c:minus>
          </c:errBars>
          <c:xVal>
            <c:numRef>
              <c:f>'Summary Printout'!$AA$104:$AA$115</c:f>
              <c:numCache>
                <c:formatCode>0.00</c:formatCode>
                <c:ptCount val="12"/>
                <c:pt idx="0">
                  <c:v>1.32436575666667</c:v>
                </c:pt>
                <c:pt idx="1">
                  <c:v>7.8346173483333299</c:v>
                </c:pt>
                <c:pt idx="2">
                  <c:v>14.396884014999999</c:v>
                </c:pt>
                <c:pt idx="3">
                  <c:v>21.009634015</c:v>
                </c:pt>
                <c:pt idx="4">
                  <c:v>27.645084014999998</c:v>
                </c:pt>
                <c:pt idx="5">
                  <c:v>34.271800681666697</c:v>
                </c:pt>
                <c:pt idx="6">
                  <c:v>40.908950681666703</c:v>
                </c:pt>
                <c:pt idx="7">
                  <c:v>47.517067348333299</c:v>
                </c:pt>
                <c:pt idx="8">
                  <c:v>54.001117348333302</c:v>
                </c:pt>
                <c:pt idx="9">
                  <c:v>60.608367348333303</c:v>
                </c:pt>
                <c:pt idx="10">
                  <c:v>67.191784014999996</c:v>
                </c:pt>
                <c:pt idx="11">
                  <c:v>73.781017348333293</c:v>
                </c:pt>
              </c:numCache>
            </c:numRef>
          </c:xVal>
          <c:yVal>
            <c:numRef>
              <c:f>'Summary Printout'!$AG$104:$AG$115</c:f>
            </c:numRef>
          </c:yVal>
          <c:smooth val="0"/>
          <c:extLst>
            <c:ext xmlns:c16="http://schemas.microsoft.com/office/drawing/2014/chart" uri="{C3380CC4-5D6E-409C-BE32-E72D297353CC}">
              <c16:uniqueId val="{00000005-30D1-1E42-AF6E-548BAA551D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2815872"/>
        <c:axId val="192818176"/>
      </c:scatterChart>
      <c:valAx>
        <c:axId val="1928158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Time (min)</a:t>
                </a:r>
              </a:p>
            </c:rich>
          </c:tx>
          <c:layout>
            <c:manualLayout>
              <c:xMode val="edge"/>
              <c:yMode val="edge"/>
              <c:x val="0.43074522457862779"/>
              <c:y val="0.82826807800637614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192818176"/>
        <c:crosses val="autoZero"/>
        <c:crossBetween val="midCat"/>
      </c:valAx>
      <c:valAx>
        <c:axId val="1928181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OCR (pmol/min)</a:t>
                </a:r>
              </a:p>
            </c:rich>
          </c:tx>
          <c:overlay val="0"/>
        </c:title>
        <c:numFmt formatCode="#0.0" sourceLinked="0"/>
        <c:majorTickMark val="out"/>
        <c:minorTickMark val="none"/>
        <c:tickLblPos val="nextTo"/>
        <c:crossAx val="192815872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aseline="0"/>
      </a:pPr>
      <a:endParaRPr lang="en-U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mmary Printout'!$CA$41</c:f>
              <c:strCache>
                <c:ptCount val="1"/>
                <c:pt idx="0">
                  <c:v>Group 1</c:v>
                </c:pt>
              </c:strCache>
            </c:strRef>
          </c:tx>
          <c:spPr>
            <a:solidFill>
              <a:srgbClr val="0070C0"/>
            </a:solidFill>
            <a:ln w="25400">
              <a:solidFill>
                <a:schemeClr val="tx1"/>
              </a:solidFill>
            </a:ln>
            <a:effectLst/>
            <a:scene3d>
              <a:camera prst="orthographicFront"/>
              <a:lightRig rig="threePt" dir="t">
                <a:rot lat="0" lon="0" rev="0"/>
              </a:lightRig>
            </a:scene3d>
            <a:sp3d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C4F6-4654-8C93-638ECD550FCC}"/>
              </c:ext>
            </c:extLst>
          </c:dPt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plus>
            <c:min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minus>
          </c:errBars>
          <c:cat>
            <c:strRef>
              <c:f>('Summary Printout'!$CD$40,'Summary Printout'!$CL$40)</c:f>
              <c:strCache>
                <c:ptCount val="2"/>
                <c:pt idx="0">
                  <c:v>Proton Leak</c:v>
                </c:pt>
                <c:pt idx="1">
                  <c:v>ATP Production</c:v>
                </c:pt>
              </c:strCache>
            </c:strRef>
          </c:cat>
          <c:val>
            <c:numRef>
              <c:f>('Summary Printout'!$CD$41,'Summary Printout'!$CL$41)</c:f>
              <c:numCache>
                <c:formatCode>#0.00</c:formatCode>
                <c:ptCount val="2"/>
                <c:pt idx="0">
                  <c:v>18.101961135864258</c:v>
                </c:pt>
                <c:pt idx="1">
                  <c:v>13.5421543121337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A5-6248-8FFA-4B4D799C9FB0}"/>
            </c:ext>
          </c:extLst>
        </c:ser>
        <c:ser>
          <c:idx val="1"/>
          <c:order val="1"/>
          <c:tx>
            <c:strRef>
              <c:f>'Summary Printout'!$CA$42</c:f>
              <c:strCache>
                <c:ptCount val="1"/>
                <c:pt idx="0">
                  <c:v>Group 2</c:v>
                </c:pt>
              </c:strCache>
            </c:strRef>
          </c:tx>
          <c:spPr>
            <a:solidFill>
              <a:schemeClr val="accent2"/>
            </a:solidFill>
            <a:ln w="25400">
              <a:noFill/>
            </a:ln>
            <a:effectLst/>
            <a:scene3d>
              <a:camera prst="orthographicFront"/>
              <a:lightRig rig="threePt" dir="t">
                <a:rot lat="0" lon="0" rev="0"/>
              </a:lightRig>
            </a:scene3d>
            <a:sp3d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0</c:v>
                </c:pt>
                <c:pt idx="1">
                  <c:v>1</c:v>
                </c:pt>
              </c:numLit>
            </c:plus>
            <c:minus>
              <c:numLit>
                <c:formatCode>General</c:formatCode>
                <c:ptCount val="2"/>
                <c:pt idx="0">
                  <c:v>0</c:v>
                </c:pt>
                <c:pt idx="1">
                  <c:v>1</c:v>
                </c:pt>
              </c:numLit>
            </c:minus>
          </c:errBars>
          <c:cat>
            <c:strRef>
              <c:f>('Summary Printout'!$CD$40,'Summary Printout'!$CL$40)</c:f>
              <c:strCache>
                <c:ptCount val="2"/>
                <c:pt idx="0">
                  <c:v>Proton Leak</c:v>
                </c:pt>
                <c:pt idx="1">
                  <c:v>ATP Production</c:v>
                </c:pt>
              </c:strCache>
            </c:strRef>
          </c:cat>
          <c:val>
            <c:numRef>
              <c:f>('Summary Printout'!$CD$42,'Summary Printout'!$CL$42)</c:f>
              <c:numCache>
                <c:formatCode>#0.00</c:formatCode>
                <c:ptCount val="2"/>
                <c:pt idx="0">
                  <c:v>22.848114013671875</c:v>
                </c:pt>
                <c:pt idx="1">
                  <c:v>16.1088409423828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EA5-6248-8FFA-4B4D799C9FB0}"/>
            </c:ext>
          </c:extLst>
        </c:ser>
        <c:ser>
          <c:idx val="2"/>
          <c:order val="2"/>
          <c:tx>
            <c:strRef>
              <c:f>'Summary Printout'!$CA$43</c:f>
              <c:strCache>
                <c:ptCount val="1"/>
                <c:pt idx="0">
                  <c:v>Group 3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  <a:ln w="25400">
              <a:noFill/>
            </a:ln>
            <a:effectLst/>
            <a:scene3d>
              <a:camera prst="orthographicFront"/>
              <a:lightRig rig="threePt" dir="t">
                <a:rot lat="0" lon="0" rev="0"/>
              </a:lightRig>
            </a:scene3d>
            <a:sp3d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plus>
            <c:min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minus>
          </c:errBars>
          <c:cat>
            <c:strRef>
              <c:f>('Summary Printout'!$CD$40,'Summary Printout'!$CL$40)</c:f>
              <c:strCache>
                <c:ptCount val="2"/>
                <c:pt idx="0">
                  <c:v>Proton Leak</c:v>
                </c:pt>
                <c:pt idx="1">
                  <c:v>ATP Production</c:v>
                </c:pt>
              </c:strCache>
            </c:strRef>
          </c:cat>
          <c:val>
            <c:numRef>
              <c:f>('Summary Printout'!$CD$43,'Summary Printout'!$CL$43)</c:f>
              <c:numCache>
                <c:formatCode>#0.00</c:formatCode>
                <c:ptCount val="2"/>
                <c:pt idx="0">
                  <c:v>15.853611946105957</c:v>
                </c:pt>
                <c:pt idx="1">
                  <c:v>12.1190643310546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EA5-6248-8FFA-4B4D799C9FB0}"/>
            </c:ext>
          </c:extLst>
        </c:ser>
        <c:ser>
          <c:idx val="3"/>
          <c:order val="3"/>
          <c:tx>
            <c:strRef>
              <c:f>'Summary Printout'!$CA$44</c:f>
              <c:strCache>
                <c:ptCount val="1"/>
                <c:pt idx="0">
                  <c:v>Group 4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 w="25400">
              <a:noFill/>
            </a:ln>
            <a:effectLst/>
            <a:scene3d>
              <a:camera prst="orthographicFront"/>
              <a:lightRig rig="threePt" dir="t">
                <a:rot lat="0" lon="0" rev="0"/>
              </a:lightRig>
            </a:scene3d>
            <a:sp3d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plus>
            <c:minus>
              <c:numLit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Lit>
            </c:minus>
          </c:errBars>
          <c:cat>
            <c:strRef>
              <c:f>('Summary Printout'!$CD$40,'Summary Printout'!$CL$40)</c:f>
              <c:strCache>
                <c:ptCount val="2"/>
                <c:pt idx="0">
                  <c:v>Proton Leak</c:v>
                </c:pt>
                <c:pt idx="1">
                  <c:v>ATP Production</c:v>
                </c:pt>
              </c:strCache>
            </c:strRef>
          </c:cat>
          <c:val>
            <c:numRef>
              <c:f>('Summary Printout'!$CD$44,'Summary Printout'!$CL$44)</c:f>
              <c:numCache>
                <c:formatCode>#0.00</c:formatCode>
                <c:ptCount val="2"/>
                <c:pt idx="0">
                  <c:v>13.026777267456055</c:v>
                </c:pt>
                <c:pt idx="1">
                  <c:v>8.67829990386962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EA5-6248-8FFA-4B4D799C9F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9660544"/>
        <c:axId val="189924480"/>
      </c:barChart>
      <c:catAx>
        <c:axId val="189660544"/>
        <c:scaling>
          <c:orientation val="minMax"/>
        </c:scaling>
        <c:delete val="0"/>
        <c:axPos val="b"/>
        <c:numFmt formatCode="#0.0" sourceLinked="0"/>
        <c:majorTickMark val="none"/>
        <c:minorTickMark val="none"/>
        <c:tickLblPos val="nextTo"/>
        <c:txPr>
          <a:bodyPr rot="0" vert="horz"/>
          <a:lstStyle/>
          <a:p>
            <a:pPr>
              <a:defRPr lang="en-US" sz="1100" b="0"/>
            </a:pPr>
            <a:endParaRPr lang="en-US"/>
          </a:p>
        </c:txPr>
        <c:crossAx val="189924480"/>
        <c:crosses val="autoZero"/>
        <c:auto val="1"/>
        <c:lblAlgn val="ctr"/>
        <c:lblOffset val="100"/>
        <c:noMultiLvlLbl val="0"/>
      </c:catAx>
      <c:valAx>
        <c:axId val="1899244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/>
                </a:pPr>
                <a:r>
                  <a:rPr lang="en-US"/>
                  <a:t>OCR (pmol/min)</a:t>
                </a:r>
              </a:p>
            </c:rich>
          </c:tx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US" sz="1100"/>
            </a:pPr>
            <a:endParaRPr lang="en-US"/>
          </a:p>
        </c:txPr>
        <c:crossAx val="189660544"/>
        <c:crosses val="autoZero"/>
        <c:crossBetween val="between"/>
      </c:valAx>
      <c:spPr>
        <a:effectLst/>
      </c:spPr>
    </c:plotArea>
    <c:plotVisOnly val="0"/>
    <c:dispBlanksAs val="gap"/>
    <c:showDLblsOverMax val="0"/>
  </c:chart>
  <c:spPr>
    <a:solidFill>
      <a:schemeClr val="bg1"/>
    </a:solidFill>
    <a:ln w="25400">
      <a:solidFill>
        <a:schemeClr val="tx1"/>
      </a:solidFill>
    </a:ln>
  </c:spPr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en-IN" sz="1800"/>
            </a:pPr>
            <a:r>
              <a:rPr lang="en-US" sz="1400" b="1" i="0" baseline="0" dirty="0">
                <a:effectLst/>
              </a:rPr>
              <a:t>Oxygen Consumption Rate</a:t>
            </a:r>
            <a:endParaRPr lang="en-IN" sz="1400" dirty="0">
              <a:effectLst/>
            </a:endParaRPr>
          </a:p>
        </c:rich>
      </c:tx>
      <c:layout>
        <c:manualLayout>
          <c:xMode val="edge"/>
          <c:yMode val="edge"/>
          <c:x val="0.26922518023896791"/>
          <c:y val="6.9623408915523294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2718449283007738"/>
          <c:y val="0.15639460229068325"/>
          <c:w val="0.70009436782529877"/>
          <c:h val="0.55465820432959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Printout'!$HA$61</c:f>
              <c:strCache>
                <c:ptCount val="1"/>
                <c:pt idx="0">
                  <c:v>Group 1</c:v>
                </c:pt>
              </c:strCache>
            </c:strRef>
          </c:tx>
          <c:spPr>
            <a:solidFill>
              <a:srgbClr val="4A7EBB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0</c:v>
                </c:pt>
              </c:numLit>
            </c:plus>
            <c:minus>
              <c:numLit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0</c:v>
                </c:pt>
              </c:numLit>
            </c:minus>
          </c:errBars>
          <c:cat>
            <c:strLit>
              <c:ptCount val="2"/>
              <c:pt idx="0">
                <c:v>Baseline</c:v>
              </c:pt>
              <c:pt idx="1">
                <c:v>Stressed</c:v>
              </c:pt>
            </c:strLit>
          </c:cat>
          <c:val>
            <c:numRef>
              <c:f>('Summary Printout'!$HB$61,'Summary Printout'!$HD$61)</c:f>
              <c:numCache>
                <c:formatCode>0.00</c:formatCode>
                <c:ptCount val="2"/>
                <c:pt idx="0">
                  <c:v>64.565528869628906</c:v>
                </c:pt>
                <c:pt idx="1">
                  <c:v>75.265495300292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15-F048-B16E-6ADA2D78D3B3}"/>
            </c:ext>
          </c:extLst>
        </c:ser>
        <c:ser>
          <c:idx val="1"/>
          <c:order val="1"/>
          <c:tx>
            <c:strRef>
              <c:f>'Summary Printout'!$HA$62</c:f>
              <c:strCache>
                <c:ptCount val="1"/>
                <c:pt idx="0">
                  <c:v>Group 2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0</c:v>
                </c:pt>
              </c:numLit>
            </c:plus>
            <c:minus>
              <c:numLit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0</c:v>
                </c:pt>
              </c:numLit>
            </c:minus>
          </c:errBars>
          <c:cat>
            <c:strRef>
              <c:f>('Summary Printout'!$HB$60,'Summary Printout'!$HD$60)</c:f>
              <c:strCache>
                <c:ptCount val="2"/>
                <c:pt idx="0">
                  <c:v>Baseline OCR</c:v>
                </c:pt>
                <c:pt idx="1">
                  <c:v>Stressed OCR</c:v>
                </c:pt>
              </c:strCache>
            </c:strRef>
          </c:cat>
          <c:val>
            <c:numRef>
              <c:f>('Summary Printout'!$HB$62,'Summary Printout'!$HD$62)</c:f>
              <c:numCache>
                <c:formatCode>0.00</c:formatCode>
                <c:ptCount val="2"/>
                <c:pt idx="0">
                  <c:v>76.294036865234375</c:v>
                </c:pt>
                <c:pt idx="1">
                  <c:v>86.6793746948242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15-F048-B16E-6ADA2D78D3B3}"/>
            </c:ext>
          </c:extLst>
        </c:ser>
        <c:ser>
          <c:idx val="2"/>
          <c:order val="2"/>
          <c:tx>
            <c:strRef>
              <c:f>'Summary Printout'!$HA$63</c:f>
              <c:strCache>
                <c:ptCount val="1"/>
                <c:pt idx="0">
                  <c:v>Group 3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0</c:v>
                </c:pt>
              </c:numLit>
            </c:plus>
            <c:minus>
              <c:numLit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0</c:v>
                </c:pt>
              </c:numLit>
            </c:minus>
          </c:errBars>
          <c:cat>
            <c:strRef>
              <c:f>('Summary Printout'!$HB$60,'Summary Printout'!$HD$60)</c:f>
              <c:strCache>
                <c:ptCount val="2"/>
                <c:pt idx="0">
                  <c:v>Baseline OCR</c:v>
                </c:pt>
                <c:pt idx="1">
                  <c:v>Stressed OCR</c:v>
                </c:pt>
              </c:strCache>
            </c:strRef>
          </c:cat>
          <c:val>
            <c:numRef>
              <c:f>('Summary Printout'!$HB$63,'Summary Printout'!$HD$63)</c:f>
              <c:numCache>
                <c:formatCode>0.00</c:formatCode>
                <c:ptCount val="2"/>
                <c:pt idx="0">
                  <c:v>63.912593841552734</c:v>
                </c:pt>
                <c:pt idx="1">
                  <c:v>71.7542953491210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315-F048-B16E-6ADA2D78D3B3}"/>
            </c:ext>
          </c:extLst>
        </c:ser>
        <c:ser>
          <c:idx val="3"/>
          <c:order val="3"/>
          <c:tx>
            <c:strRef>
              <c:f>'Summary Printout'!$HA$64</c:f>
              <c:strCache>
                <c:ptCount val="1"/>
                <c:pt idx="0">
                  <c:v>Group 4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0</c:v>
                </c:pt>
              </c:numLit>
            </c:plus>
            <c:minus>
              <c:numLit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0</c:v>
                </c:pt>
              </c:numLit>
            </c:minus>
          </c:errBars>
          <c:cat>
            <c:strRef>
              <c:f>('Summary Printout'!$HB$60,'Summary Printout'!$HD$60)</c:f>
              <c:strCache>
                <c:ptCount val="2"/>
                <c:pt idx="0">
                  <c:v>Baseline OCR</c:v>
                </c:pt>
                <c:pt idx="1">
                  <c:v>Stressed OCR</c:v>
                </c:pt>
              </c:strCache>
            </c:strRef>
          </c:cat>
          <c:val>
            <c:numRef>
              <c:f>('Summary Printout'!$HB$64,'Summary Printout'!$HD$64)</c:f>
              <c:numCache>
                <c:formatCode>0.00</c:formatCode>
                <c:ptCount val="2"/>
                <c:pt idx="0">
                  <c:v>51.145511627197266</c:v>
                </c:pt>
                <c:pt idx="1">
                  <c:v>54.2496719360351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15-F048-B16E-6ADA2D78D3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6578944"/>
        <c:axId val="116588928"/>
      </c:barChart>
      <c:catAx>
        <c:axId val="1165789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en-US" sz="1200" b="1" baseline="0">
                <a:latin typeface="+mn-lt"/>
              </a:defRPr>
            </a:pPr>
            <a:endParaRPr lang="en-US"/>
          </a:p>
        </c:txPr>
        <c:crossAx val="116588928"/>
        <c:crosses val="autoZero"/>
        <c:auto val="1"/>
        <c:lblAlgn val="ctr"/>
        <c:lblOffset val="100"/>
        <c:noMultiLvlLbl val="0"/>
      </c:catAx>
      <c:valAx>
        <c:axId val="1165889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IN" sz="1200"/>
                </a:pPr>
                <a:r>
                  <a:rPr lang="en-IN" sz="1200"/>
                  <a:t>OCR (pmol/min)</a:t>
                </a:r>
              </a:p>
            </c:rich>
          </c:tx>
          <c:layout>
            <c:manualLayout>
              <c:xMode val="edge"/>
              <c:yMode val="edge"/>
              <c:x val="6.5517742461333933E-2"/>
              <c:y val="0.30098745312664604"/>
            </c:manualLayout>
          </c:layout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US" sz="1200" b="0"/>
            </a:pPr>
            <a:endParaRPr lang="en-US"/>
          </a:p>
        </c:txPr>
        <c:crossAx val="116578944"/>
        <c:crosses val="autoZero"/>
        <c:crossBetween val="between"/>
      </c:valAx>
      <c:spPr>
        <a:ln w="9525">
          <a:solidFill>
            <a:schemeClr val="bg1">
              <a:lumMod val="65000"/>
            </a:schemeClr>
          </a:solidFill>
        </a:ln>
        <a:effectLst/>
      </c:spPr>
    </c:plotArea>
    <c:plotVisOnly val="0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en-IN"/>
            </a:pPr>
            <a:r>
              <a:rPr lang="en-IN" sz="1400" dirty="0"/>
              <a:t>XF Cell Energy Phenotype</a:t>
            </a:r>
          </a:p>
        </c:rich>
      </c:tx>
      <c:layout>
        <c:manualLayout>
          <c:xMode val="edge"/>
          <c:yMode val="edge"/>
          <c:x val="0.28690276642010754"/>
          <c:y val="4.5220481125500499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2536413410150241"/>
          <c:y val="0.13027254278328074"/>
          <c:w val="0.63218980169023276"/>
          <c:h val="0.49481860856896648"/>
        </c:manualLayout>
      </c:layout>
      <c:scatterChart>
        <c:scatterStyle val="smoothMarker"/>
        <c:varyColors val="0"/>
        <c:ser>
          <c:idx val="0"/>
          <c:order val="0"/>
          <c:tx>
            <c:v>Group 1</c:v>
          </c:tx>
          <c:spPr>
            <a:ln w="15875">
              <a:solidFill>
                <a:srgbClr val="416FA6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416FA6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1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1:$IH$61</c:f>
                <c:numCache>
                  <c:formatCode>General</c:formatCode>
                  <c:ptCount val="2"/>
                  <c:pt idx="0">
                    <c:v>2.5209152698516846</c:v>
                  </c:pt>
                  <c:pt idx="1">
                    <c:v>3.25937819480896</c:v>
                  </c:pt>
                </c:numCache>
              </c:numRef>
            </c:plus>
            <c:minus>
              <c:numRef>
                <c:f>'Summary Printout'!$IG$61:$IH$61</c:f>
                <c:numCache>
                  <c:formatCode>General</c:formatCode>
                  <c:ptCount val="2"/>
                  <c:pt idx="0">
                    <c:v>2.5209152698516846</c:v>
                  </c:pt>
                  <c:pt idx="1">
                    <c:v>3.25937819480896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1:$IF$61</c:f>
                <c:numCache>
                  <c:formatCode>General</c:formatCode>
                  <c:ptCount val="2"/>
                  <c:pt idx="0">
                    <c:v>1.4935623407363892</c:v>
                  </c:pt>
                  <c:pt idx="1">
                    <c:v>1.782351016998291</c:v>
                  </c:pt>
                </c:numCache>
              </c:numRef>
            </c:plus>
            <c:minus>
              <c:numRef>
                <c:f>'Summary Printout'!$IE$61:$IF$61</c:f>
                <c:numCache>
                  <c:formatCode>General</c:formatCode>
                  <c:ptCount val="2"/>
                  <c:pt idx="0">
                    <c:v>1.4935623407363892</c:v>
                  </c:pt>
                  <c:pt idx="1">
                    <c:v>1.782351016998291</c:v>
                  </c:pt>
                </c:numCache>
              </c:numRef>
            </c:minus>
          </c:errBars>
          <c:xVal>
            <c:numRef>
              <c:f>'Summary Printout'!$IA$61:$IB$61</c:f>
              <c:numCache>
                <c:formatCode>0.00</c:formatCode>
                <c:ptCount val="2"/>
                <c:pt idx="0">
                  <c:v>28.084053039550781</c:v>
                </c:pt>
                <c:pt idx="1">
                  <c:v>40.865055084228516</c:v>
                </c:pt>
              </c:numCache>
            </c:numRef>
          </c:xVal>
          <c:yVal>
            <c:numRef>
              <c:f>'Summary Printout'!$IC$61:$ID$61</c:f>
              <c:numCache>
                <c:formatCode>0.00</c:formatCode>
                <c:ptCount val="2"/>
                <c:pt idx="0">
                  <c:v>66.861442565917969</c:v>
                </c:pt>
                <c:pt idx="1">
                  <c:v>77.93214416503906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264-F24B-9A1C-C0F9597E0A9F}"/>
            </c:ext>
          </c:extLst>
        </c:ser>
        <c:ser>
          <c:idx val="1"/>
          <c:order val="1"/>
          <c:tx>
            <c:v>Group 2</c:v>
          </c:tx>
          <c:spPr>
            <a:ln w="15875">
              <a:solidFill>
                <a:srgbClr val="A8423F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A8423F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4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2:$IH$62</c:f>
                <c:numCache>
                  <c:formatCode>General</c:formatCode>
                  <c:ptCount val="2"/>
                  <c:pt idx="0">
                    <c:v>1.9723794460296631</c:v>
                  </c:pt>
                  <c:pt idx="1">
                    <c:v>2.830371618270874</c:v>
                  </c:pt>
                </c:numCache>
              </c:numRef>
            </c:plus>
            <c:minus>
              <c:numRef>
                <c:f>'Summary Printout'!$IG$62:$IH$62</c:f>
                <c:numCache>
                  <c:formatCode>General</c:formatCode>
                  <c:ptCount val="2"/>
                  <c:pt idx="0">
                    <c:v>1.9723794460296631</c:v>
                  </c:pt>
                  <c:pt idx="1">
                    <c:v>2.830371618270874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2:$IF$62</c:f>
                <c:numCache>
                  <c:formatCode>General</c:formatCode>
                  <c:ptCount val="2"/>
                  <c:pt idx="0">
                    <c:v>1.2529850006103516</c:v>
                  </c:pt>
                  <c:pt idx="1">
                    <c:v>1.6322178840637207</c:v>
                  </c:pt>
                </c:numCache>
              </c:numRef>
            </c:plus>
            <c:minus>
              <c:numRef>
                <c:f>'Summary Printout'!$IE$62:$IF$62</c:f>
                <c:numCache>
                  <c:formatCode>General</c:formatCode>
                  <c:ptCount val="2"/>
                  <c:pt idx="0">
                    <c:v>1.2529850006103516</c:v>
                  </c:pt>
                  <c:pt idx="1">
                    <c:v>1.6322178840637207</c:v>
                  </c:pt>
                </c:numCache>
              </c:numRef>
            </c:minus>
          </c:errBars>
          <c:xVal>
            <c:numRef>
              <c:f>'Summary Printout'!$IA$62:$IB$62</c:f>
              <c:numCache>
                <c:formatCode>0.00</c:formatCode>
                <c:ptCount val="2"/>
                <c:pt idx="0">
                  <c:v>31.691213607788086</c:v>
                </c:pt>
                <c:pt idx="1">
                  <c:v>44.149929046630859</c:v>
                </c:pt>
              </c:numCache>
            </c:numRef>
          </c:xVal>
          <c:yVal>
            <c:numRef>
              <c:f>'Summary Printout'!$IC$62:$ID$62</c:f>
              <c:numCache>
                <c:formatCode>0.00</c:formatCode>
                <c:ptCount val="2"/>
                <c:pt idx="0">
                  <c:v>76.294036865234375</c:v>
                </c:pt>
                <c:pt idx="1">
                  <c:v>86.67937469482421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5264-F24B-9A1C-C0F9597E0A9F}"/>
            </c:ext>
          </c:extLst>
        </c:ser>
        <c:ser>
          <c:idx val="2"/>
          <c:order val="2"/>
          <c:tx>
            <c:v>Group 3</c:v>
          </c:tx>
          <c:spPr>
            <a:ln w="15875">
              <a:solidFill>
                <a:srgbClr val="86A44A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86A44A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7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3:$IH$63</c:f>
                <c:numCache>
                  <c:formatCode>General</c:formatCode>
                  <c:ptCount val="2"/>
                  <c:pt idx="0">
                    <c:v>2.3318793773651123</c:v>
                  </c:pt>
                  <c:pt idx="1">
                    <c:v>3.1506557464599609</c:v>
                  </c:pt>
                </c:numCache>
              </c:numRef>
            </c:plus>
            <c:minus>
              <c:numRef>
                <c:f>'Summary Printout'!$IG$63:$IH$63</c:f>
                <c:numCache>
                  <c:formatCode>General</c:formatCode>
                  <c:ptCount val="2"/>
                  <c:pt idx="0">
                    <c:v>2.3318793773651123</c:v>
                  </c:pt>
                  <c:pt idx="1">
                    <c:v>3.1506557464599609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3:$IF$63</c:f>
                <c:numCache>
                  <c:formatCode>General</c:formatCode>
                  <c:ptCount val="2"/>
                  <c:pt idx="0">
                    <c:v>1.4771171808242798</c:v>
                  </c:pt>
                  <c:pt idx="1">
                    <c:v>1.8196297883987427</c:v>
                  </c:pt>
                </c:numCache>
              </c:numRef>
            </c:plus>
            <c:minus>
              <c:numRef>
                <c:f>'Summary Printout'!$IE$63:$IF$63</c:f>
                <c:numCache>
                  <c:formatCode>General</c:formatCode>
                  <c:ptCount val="2"/>
                  <c:pt idx="0">
                    <c:v>1.4771171808242798</c:v>
                  </c:pt>
                  <c:pt idx="1">
                    <c:v>1.8196297883987427</c:v>
                  </c:pt>
                </c:numCache>
              </c:numRef>
            </c:minus>
          </c:errBars>
          <c:xVal>
            <c:numRef>
              <c:f>'Summary Printout'!$IA$63:$IB$63</c:f>
              <c:numCache>
                <c:formatCode>0.00</c:formatCode>
                <c:ptCount val="2"/>
                <c:pt idx="0">
                  <c:v>19.889570236206055</c:v>
                </c:pt>
                <c:pt idx="1">
                  <c:v>31.217006683349609</c:v>
                </c:pt>
              </c:numCache>
            </c:numRef>
          </c:xVal>
          <c:yVal>
            <c:numRef>
              <c:f>'Summary Printout'!$IC$63:$ID$63</c:f>
              <c:numCache>
                <c:formatCode>0.00</c:formatCode>
                <c:ptCount val="2"/>
                <c:pt idx="0">
                  <c:v>60.223232269287109</c:v>
                </c:pt>
                <c:pt idx="1">
                  <c:v>66.84233856201171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5264-F24B-9A1C-C0F9597E0A9F}"/>
            </c:ext>
          </c:extLst>
        </c:ser>
        <c:ser>
          <c:idx val="3"/>
          <c:order val="3"/>
          <c:tx>
            <c:v>Group 4</c:v>
          </c:tx>
          <c:spPr>
            <a:ln w="15875">
              <a:solidFill>
                <a:srgbClr val="6E548D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6E548D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A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4:$IH$64</c:f>
                <c:numCache>
                  <c:formatCode>General</c:formatCode>
                  <c:ptCount val="2"/>
                  <c:pt idx="0">
                    <c:v>2.3952677249908447</c:v>
                  </c:pt>
                  <c:pt idx="1">
                    <c:v>3.0706274509429932</c:v>
                  </c:pt>
                </c:numCache>
              </c:numRef>
            </c:plus>
            <c:minus>
              <c:numRef>
                <c:f>'Summary Printout'!$IG$64:$IH$64</c:f>
                <c:numCache>
                  <c:formatCode>General</c:formatCode>
                  <c:ptCount val="2"/>
                  <c:pt idx="0">
                    <c:v>2.3952677249908447</c:v>
                  </c:pt>
                  <c:pt idx="1">
                    <c:v>3.0706274509429932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4:$IF$64</c:f>
                <c:numCache>
                  <c:formatCode>General</c:formatCode>
                  <c:ptCount val="2"/>
                  <c:pt idx="0">
                    <c:v>1.5911328792572021</c:v>
                  </c:pt>
                  <c:pt idx="1">
                    <c:v>2.1370987892150879</c:v>
                  </c:pt>
                </c:numCache>
              </c:numRef>
            </c:plus>
            <c:minus>
              <c:numRef>
                <c:f>'Summary Printout'!$IE$64:$IF$64</c:f>
                <c:numCache>
                  <c:formatCode>General</c:formatCode>
                  <c:ptCount val="2"/>
                  <c:pt idx="0">
                    <c:v>1.5911328792572021</c:v>
                  </c:pt>
                  <c:pt idx="1">
                    <c:v>2.1370987892150879</c:v>
                  </c:pt>
                </c:numCache>
              </c:numRef>
            </c:minus>
          </c:errBars>
          <c:xVal>
            <c:numRef>
              <c:f>'Summary Printout'!$IA$64:$IB$64</c:f>
              <c:numCache>
                <c:formatCode>0.00</c:formatCode>
                <c:ptCount val="2"/>
                <c:pt idx="0">
                  <c:v>16.963005065917969</c:v>
                </c:pt>
                <c:pt idx="1">
                  <c:v>23.63050651550293</c:v>
                </c:pt>
              </c:numCache>
            </c:numRef>
          </c:xVal>
          <c:yVal>
            <c:numRef>
              <c:f>'Summary Printout'!$IC$64:$ID$64</c:f>
              <c:numCache>
                <c:formatCode>0.00</c:formatCode>
                <c:ptCount val="2"/>
                <c:pt idx="0">
                  <c:v>47.826614379882813</c:v>
                </c:pt>
                <c:pt idx="1">
                  <c:v>50.43898010253906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B-5264-F24B-9A1C-C0F9597E0A9F}"/>
            </c:ext>
          </c:extLst>
        </c:ser>
        <c:ser>
          <c:idx val="4"/>
          <c:order val="4"/>
          <c:tx>
            <c:v/>
          </c:tx>
          <c:spPr>
            <a:ln w="15875">
              <a:solidFill>
                <a:srgbClr val="000000"/>
              </a:solidFill>
              <a:prstDash val="lgDash"/>
            </a:ln>
          </c:spPr>
          <c:marker>
            <c:symbol val="square"/>
            <c:size val="10"/>
            <c:spPr>
              <a:ln w="15875"/>
            </c:spPr>
          </c:marker>
          <c:dPt>
            <c:idx val="0"/>
            <c:marker>
              <c:spPr>
                <a:solidFill>
                  <a:srgbClr val="FFFFFF"/>
                </a:solidFill>
                <a:ln w="25400"/>
              </c:spPr>
            </c:marker>
            <c:bubble3D val="0"/>
            <c:spPr>
              <a:ln w="25400">
                <a:solidFill>
                  <a:srgbClr val="000000"/>
                </a:solidFill>
                <a:prstDash val="lgDash"/>
              </a:ln>
            </c:spPr>
            <c:extLst>
              <c:ext xmlns:c16="http://schemas.microsoft.com/office/drawing/2014/chart" uri="{C3380CC4-5D6E-409C-BE32-E72D297353CC}">
                <c16:uniqueId val="{0000000D-5264-F24B-9A1C-C0F9597E0A9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Summary Printout'!$IG$65:$IH$65</c:f>
                <c:numCache>
                  <c:formatCode>General</c:formatCode>
                  <c:ptCount val="2"/>
                </c:numCache>
              </c:numRef>
            </c:plus>
            <c:minus>
              <c:numRef>
                <c:f>'Summary Printout'!$IG$65:$IH$65</c:f>
                <c:numCache>
                  <c:formatCode>General</c:formatCode>
                  <c:ptCount val="2"/>
                </c:numCache>
              </c:numRef>
            </c:minus>
          </c:errBars>
          <c:errBars>
            <c:errDir val="x"/>
            <c:errBarType val="both"/>
            <c:errValType val="cust"/>
            <c:noEndCap val="0"/>
            <c:plus>
              <c:numRef>
                <c:f>'Summary Printout'!$IE$65:$IF$65</c:f>
                <c:numCache>
                  <c:formatCode>General</c:formatCode>
                  <c:ptCount val="2"/>
                </c:numCache>
              </c:numRef>
            </c:plus>
            <c:minus>
              <c:numRef>
                <c:f>'Summary Printout'!$IE$65:$IF$65</c:f>
                <c:numCache>
                  <c:formatCode>General</c:formatCode>
                  <c:ptCount val="2"/>
                </c:numCache>
              </c:numRef>
            </c:minus>
          </c:errBars>
          <c:xVal>
            <c:numRef>
              <c:f>'Summary Printout'!$IA$65:$IB$65</c:f>
              <c:numCache>
                <c:formatCode>General</c:formatCode>
                <c:ptCount val="2"/>
              </c:numCache>
            </c:numRef>
          </c:xVal>
          <c:yVal>
            <c:numRef>
              <c:f>'Summary Printout'!$IC$65:$ID$65</c:f>
              <c:numCache>
                <c:formatCode>General</c:formatCode>
                <c:ptCount val="2"/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E-5264-F24B-9A1C-C0F9597E0A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7035776"/>
        <c:axId val="117037696"/>
      </c:scatterChart>
      <c:valAx>
        <c:axId val="117035776"/>
        <c:scaling>
          <c:orientation val="minMax"/>
          <c:max val="95.78214693069458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lang="en-IN" sz="1600"/>
                </a:pPr>
                <a:r>
                  <a:rPr lang="en-US" sz="1200" dirty="0"/>
                  <a:t>ECAR (</a:t>
                </a:r>
                <a:r>
                  <a:rPr lang="en-US" sz="1200" dirty="0" err="1"/>
                  <a:t>mpH</a:t>
                </a:r>
                <a:r>
                  <a:rPr lang="en-US" sz="1200" dirty="0"/>
                  <a:t>/min)
Glycolysis</a:t>
                </a:r>
              </a:p>
            </c:rich>
          </c:tx>
          <c:layout>
            <c:manualLayout>
              <c:xMode val="edge"/>
              <c:yMode val="edge"/>
              <c:x val="0.3536148578941814"/>
              <c:y val="0.69321023491650369"/>
            </c:manualLayout>
          </c:layout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IN" sz="1200"/>
            </a:pPr>
            <a:endParaRPr lang="en-US"/>
          </a:p>
        </c:txPr>
        <c:crossAx val="117037696"/>
        <c:crosses val="autoZero"/>
        <c:crossBetween val="midCat"/>
      </c:valAx>
      <c:valAx>
        <c:axId val="117037696"/>
        <c:scaling>
          <c:orientation val="minMax"/>
          <c:max val="9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lang="en-IN" sz="1600"/>
                </a:pPr>
                <a:r>
                  <a:rPr lang="en-US" sz="1200" dirty="0"/>
                  <a:t>Mitochondrial Respiration
OCR (</a:t>
                </a:r>
                <a:r>
                  <a:rPr lang="en-US" sz="1200" dirty="0" err="1"/>
                  <a:t>pmol</a:t>
                </a:r>
                <a:r>
                  <a:rPr lang="en-US" sz="1200" dirty="0"/>
                  <a:t>/min)</a:t>
                </a:r>
              </a:p>
            </c:rich>
          </c:tx>
          <c:layout>
            <c:manualLayout>
              <c:xMode val="edge"/>
              <c:yMode val="edge"/>
              <c:x val="5.0431755922536792E-2"/>
              <c:y val="0.19350589466216528"/>
            </c:manualLayout>
          </c:layout>
          <c:overlay val="0"/>
        </c:title>
        <c:numFmt formatCode="#0.0" sourceLinked="0"/>
        <c:majorTickMark val="out"/>
        <c:minorTickMark val="none"/>
        <c:tickLblPos val="nextTo"/>
        <c:txPr>
          <a:bodyPr/>
          <a:lstStyle/>
          <a:p>
            <a:pPr>
              <a:defRPr lang="en-IN" sz="1200"/>
            </a:pPr>
            <a:endParaRPr lang="en-US"/>
          </a:p>
        </c:txPr>
        <c:crossAx val="117035776"/>
        <c:crosses val="autoZero"/>
        <c:crossBetween val="midCat"/>
      </c:valAx>
      <c:spPr>
        <a:ln w="9525" cmpd="sng">
          <a:solidFill>
            <a:srgbClr val="A6A6A6"/>
          </a:solidFill>
          <a:prstDash val="solid"/>
        </a:ln>
      </c:spPr>
    </c:plotArea>
    <c:plotVisOnly val="0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other cells'!$E$54</c:f>
              <c:strCache>
                <c:ptCount val="1"/>
                <c:pt idx="0">
                  <c:v>scrambled contr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E$58:$G$58</c:f>
                <c:numCache>
                  <c:formatCode>General</c:formatCode>
                  <c:ptCount val="3"/>
                  <c:pt idx="0">
                    <c:v>4.9999999999998657E-4</c:v>
                  </c:pt>
                  <c:pt idx="1">
                    <c:v>2.1875000000001754E-4</c:v>
                  </c:pt>
                  <c:pt idx="2">
                    <c:v>8.4374999999997646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D$55:$D$56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E$55:$E$56</c:f>
              <c:numCache>
                <c:formatCode>General</c:formatCode>
                <c:ptCount val="2"/>
                <c:pt idx="0">
                  <c:v>0.12574999999999997</c:v>
                </c:pt>
                <c:pt idx="1">
                  <c:v>0.17678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0B-45E9-A867-872CC268D59B}"/>
            </c:ext>
          </c:extLst>
        </c:ser>
        <c:ser>
          <c:idx val="1"/>
          <c:order val="1"/>
          <c:tx>
            <c:strRef>
              <c:f>'other cells'!$F$54</c:f>
              <c:strCache>
                <c:ptCount val="1"/>
                <c:pt idx="0">
                  <c:v>si-circNFATc3-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F$58:$F$59</c:f>
                <c:numCache>
                  <c:formatCode>General</c:formatCode>
                  <c:ptCount val="2"/>
                  <c:pt idx="0">
                    <c:v>2.1875000000001754E-4</c:v>
                  </c:pt>
                  <c:pt idx="1">
                    <c:v>1.6874999999999807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D$55:$D$56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F$55:$F$56</c:f>
              <c:numCache>
                <c:formatCode>General</c:formatCode>
                <c:ptCount val="2"/>
                <c:pt idx="0">
                  <c:v>0.12728125000000001</c:v>
                </c:pt>
                <c:pt idx="1">
                  <c:v>0.1744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C0B-45E9-A867-872CC268D59B}"/>
            </c:ext>
          </c:extLst>
        </c:ser>
        <c:ser>
          <c:idx val="2"/>
          <c:order val="2"/>
          <c:tx>
            <c:strRef>
              <c:f>'other cells'!$G$54</c:f>
              <c:strCache>
                <c:ptCount val="1"/>
                <c:pt idx="0">
                  <c:v>si-circNFATC3-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G$58:$G$59</c:f>
                <c:numCache>
                  <c:formatCode>General</c:formatCode>
                  <c:ptCount val="2"/>
                  <c:pt idx="0">
                    <c:v>8.4374999999997646E-4</c:v>
                  </c:pt>
                  <c:pt idx="1">
                    <c:v>1.6249999999999876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D$55:$D$56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G$55:$G$56</c:f>
              <c:numCache>
                <c:formatCode>General</c:formatCode>
                <c:ptCount val="2"/>
                <c:pt idx="0">
                  <c:v>0.12965625</c:v>
                </c:pt>
                <c:pt idx="1">
                  <c:v>0.16724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C0B-45E9-A867-872CC268D5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38325792"/>
        <c:axId val="1341102816"/>
      </c:barChart>
      <c:catAx>
        <c:axId val="1538325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41102816"/>
        <c:crosses val="autoZero"/>
        <c:auto val="1"/>
        <c:lblAlgn val="ctr"/>
        <c:lblOffset val="100"/>
        <c:noMultiLvlLbl val="0"/>
      </c:catAx>
      <c:valAx>
        <c:axId val="13411028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38325792"/>
        <c:crosses val="autoZero"/>
        <c:crossBetween val="between"/>
      </c:valAx>
      <c:spPr>
        <a:noFill/>
        <a:ln>
          <a:solidFill>
            <a:schemeClr val="bg1">
              <a:lumMod val="85000"/>
            </a:schemeClr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800"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536365163796631"/>
          <c:y val="8.5856299212598422E-2"/>
          <c:w val="0.77352513134437095"/>
          <c:h val="0.683810907617197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other cells'!$S$25</c:f>
              <c:strCache>
                <c:ptCount val="1"/>
                <c:pt idx="0">
                  <c:v>scrambled control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bg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S$28:$S$29</c:f>
                <c:numCache>
                  <c:formatCode>General</c:formatCode>
                  <c:ptCount val="2"/>
                  <c:pt idx="0">
                    <c:v>32.5</c:v>
                  </c:pt>
                  <c:pt idx="1">
                    <c:v>1959.45833333333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R$26:$R$27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S$26:$S$27</c:f>
              <c:numCache>
                <c:formatCode>General</c:formatCode>
                <c:ptCount val="2"/>
                <c:pt idx="0">
                  <c:v>181013.25</c:v>
                </c:pt>
                <c:pt idx="1">
                  <c:v>116487.208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18-4400-9E64-8F14E08E3D97}"/>
            </c:ext>
          </c:extLst>
        </c:ser>
        <c:ser>
          <c:idx val="1"/>
          <c:order val="1"/>
          <c:tx>
            <c:strRef>
              <c:f>'other cells'!$T$25</c:f>
              <c:strCache>
                <c:ptCount val="1"/>
                <c:pt idx="0">
                  <c:v>si-circNFATc3-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T$28:$T$29</c:f>
                <c:numCache>
                  <c:formatCode>General</c:formatCode>
                  <c:ptCount val="2"/>
                  <c:pt idx="0">
                    <c:v>524.75</c:v>
                  </c:pt>
                  <c:pt idx="1">
                    <c:v>3670.90476190476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R$26:$R$27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T$26:$T$27</c:f>
              <c:numCache>
                <c:formatCode>General</c:formatCode>
                <c:ptCount val="2"/>
                <c:pt idx="0">
                  <c:v>185888.5</c:v>
                </c:pt>
                <c:pt idx="1">
                  <c:v>122745.761904761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18-4400-9E64-8F14E08E3D97}"/>
            </c:ext>
          </c:extLst>
        </c:ser>
        <c:ser>
          <c:idx val="2"/>
          <c:order val="2"/>
          <c:tx>
            <c:strRef>
              <c:f>'other cells'!$U$25</c:f>
              <c:strCache>
                <c:ptCount val="1"/>
                <c:pt idx="0">
                  <c:v>si-circNFATC3-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ther cells'!$U$28:$U$29</c:f>
                <c:numCache>
                  <c:formatCode>General</c:formatCode>
                  <c:ptCount val="2"/>
                  <c:pt idx="0">
                    <c:v>2890.3030303030391</c:v>
                  </c:pt>
                  <c:pt idx="1">
                    <c:v>990.71428571428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ther cells'!$R$26:$R$27</c:f>
              <c:strCache>
                <c:ptCount val="2"/>
                <c:pt idx="0">
                  <c:v>healthyLCL</c:v>
                </c:pt>
                <c:pt idx="1">
                  <c:v>TNBC-LCL</c:v>
                </c:pt>
              </c:strCache>
            </c:strRef>
          </c:cat>
          <c:val>
            <c:numRef>
              <c:f>'other cells'!$U$26:$U$27</c:f>
              <c:numCache>
                <c:formatCode>General</c:formatCode>
                <c:ptCount val="2"/>
                <c:pt idx="0">
                  <c:v>182344.9696969697</c:v>
                </c:pt>
                <c:pt idx="1">
                  <c:v>116765.285714285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18-4400-9E64-8F14E08E3D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48046720"/>
        <c:axId val="1539057616"/>
      </c:barChart>
      <c:catAx>
        <c:axId val="1448046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39057616"/>
        <c:crosses val="autoZero"/>
        <c:auto val="1"/>
        <c:lblAlgn val="ctr"/>
        <c:lblOffset val="100"/>
        <c:noMultiLvlLbl val="0"/>
      </c:catAx>
      <c:valAx>
        <c:axId val="15390576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8046720"/>
        <c:crosses val="autoZero"/>
        <c:crossBetween val="between"/>
      </c:valAx>
      <c:spPr>
        <a:noFill/>
        <a:ln>
          <a:solidFill>
            <a:schemeClr val="bg1"/>
          </a:solidFill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800"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drawing3.xml.rels><?xml version="1.0" encoding="UTF-8" standalone="yes"?>
<Relationships xmlns="http://schemas.openxmlformats.org/package/2006/relationships"><Relationship Id="rId1" Type="http://schemas.openxmlformats.org/officeDocument/2006/relationships/image" Target="../media/image5.tiff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image" Target="../media/image6.w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22522</cdr:y>
    </cdr:from>
    <cdr:to>
      <cdr:x>0.37169</cdr:x>
      <cdr:y>0.76716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63500" y="496293"/>
          <a:ext cx="1041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/>
            <a:t>Fold expression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69786</cdr:x>
      <cdr:y>0.64025</cdr:y>
    </cdr:from>
    <cdr:to>
      <cdr:x>0.8256</cdr:x>
      <cdr:y>0.8126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995788" y="3395588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Si-circNFATC3-1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9418</cdr:x>
      <cdr:y>0.69496</cdr:y>
    </cdr:from>
    <cdr:to>
      <cdr:x>0.8563</cdr:x>
      <cdr:y>0.88561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4969411" y="3685735"/>
          <a:ext cx="1160585" cy="10111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/>
            <a:t>Si-circNFATC3-2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68529</cdr:x>
      <cdr:y>0.03049</cdr:y>
    </cdr:from>
    <cdr:to>
      <cdr:x>0.77166</cdr:x>
      <cdr:y>0.31505</cdr:y>
    </cdr:to>
    <cdr:pic>
      <cdr:nvPicPr>
        <cdr:cNvPr id="2" name="chart">
          <a:extLst xmlns:a="http://schemas.openxmlformats.org/drawingml/2006/main">
            <a:ext uri="{FF2B5EF4-FFF2-40B4-BE49-F238E27FC236}">
              <a16:creationId xmlns:a16="http://schemas.microsoft.com/office/drawing/2014/main" id="{DA9C2C86-F441-F443-8871-F246C63440A5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4273914" y="108743"/>
          <a:ext cx="538608" cy="1014801"/>
        </a:xfrm>
        <a:prstGeom xmlns:a="http://schemas.openxmlformats.org/drawingml/2006/main" prst="rect">
          <a:avLst/>
        </a:prstGeom>
      </cdr:spPr>
    </cdr:pic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22437</cdr:x>
      <cdr:y>0.12818</cdr:y>
    </cdr:from>
    <cdr:to>
      <cdr:x>0.37901</cdr:x>
      <cdr:y>0.1755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111323" y="673016"/>
          <a:ext cx="765932" cy="2486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000" b="1"/>
            <a:t>Aerobic</a:t>
          </a:r>
        </a:p>
      </cdr:txBody>
    </cdr:sp>
  </cdr:relSizeAnchor>
  <cdr:relSizeAnchor xmlns:cdr="http://schemas.openxmlformats.org/drawingml/2006/chartDrawing">
    <cdr:from>
      <cdr:x>0.74018</cdr:x>
      <cdr:y>0.12713</cdr:y>
    </cdr:from>
    <cdr:to>
      <cdr:x>0.88049</cdr:x>
      <cdr:y>0.17891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4200752" y="661966"/>
          <a:ext cx="796327" cy="2696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000" b="1" dirty="0"/>
            <a:t>Energetic</a:t>
          </a:r>
        </a:p>
      </cdr:txBody>
    </cdr:sp>
  </cdr:relSizeAnchor>
  <cdr:relSizeAnchor xmlns:cdr="http://schemas.openxmlformats.org/drawingml/2006/chartDrawing">
    <cdr:from>
      <cdr:x>0.74434</cdr:x>
      <cdr:y>0.57508</cdr:y>
    </cdr:from>
    <cdr:to>
      <cdr:x>0.90414</cdr:x>
      <cdr:y>0.62121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3686702" y="3019547"/>
          <a:ext cx="791489" cy="242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000" b="1"/>
            <a:t>Glycolytic</a:t>
          </a:r>
        </a:p>
      </cdr:txBody>
    </cdr:sp>
  </cdr:relSizeAnchor>
  <cdr:relSizeAnchor xmlns:cdr="http://schemas.openxmlformats.org/drawingml/2006/chartDrawing">
    <cdr:from>
      <cdr:x>0.21751</cdr:x>
      <cdr:y>0.57291</cdr:y>
    </cdr:from>
    <cdr:to>
      <cdr:x>0.3773</cdr:x>
      <cdr:y>0.61905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1077327" y="3008166"/>
          <a:ext cx="791440" cy="24226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000" b="1"/>
            <a:t>Quiescent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02217</cdr:x>
      <cdr:y>0.26329</cdr:y>
    </cdr:from>
    <cdr:to>
      <cdr:x>0.08202</cdr:x>
      <cdr:y>0.66433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7577E41C-996B-42BC-8EF6-74673523F571}"/>
            </a:ext>
          </a:extLst>
        </cdr:cNvPr>
        <cdr:cNvSpPr txBox="1"/>
      </cdr:nvSpPr>
      <cdr:spPr>
        <a:xfrm xmlns:a="http://schemas.openxmlformats.org/drawingml/2006/main" rot="16200000">
          <a:off x="-580170" y="1826656"/>
          <a:ext cx="1717852" cy="3202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200" b="1" dirty="0">
              <a:solidFill>
                <a:schemeClr val="tx1"/>
              </a:solidFill>
            </a:rPr>
            <a:t>Relative Luminescence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Q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1C44DE-E6D4-DA4F-A9D5-B77FA2E67022}" type="datetimeFigureOut">
              <a:rPr lang="en-QA" smtClean="0"/>
              <a:t>02/19/2021</a:t>
            </a:fld>
            <a:endParaRPr lang="en-Q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Q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Q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E9C332-F9F7-8C45-BB62-DC912BE9BDD2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15049985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FE9C332-F9F7-8C45-BB62-DC912BE9BDD2}" type="slidenum">
              <a:rPr lang="en-QA" smtClean="0"/>
              <a:t>2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39685459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62A52B-DB35-4A2E-969A-51524580B7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E19EA3-746D-4CC7-BDD1-A79C5950C9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D114C9-336B-4D4E-A224-C6FB64CBF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3D7E4B-B40C-4E5C-88DE-A2D11FA51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DF27E9-932F-479B-B645-5D0BDF1EFD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401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B534C1-7C0B-410D-B1BC-6ECF5B3CFA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1BE327-B0A8-41E3-8A6E-AF56111CCE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3F859E-B876-4B89-825F-1D343AD9B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CEB182-5736-4803-9E0E-C1F155194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D1E5C-E5C4-4DC4-9038-F01F65743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766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8DF206-3A90-43CD-AF38-C448EF1DBD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36D928-F684-4EB6-92B5-5FC05F1AB4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C4B6AE-975A-4642-8435-3E49C42E4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8BDEF-6177-4593-BFC1-98290C9A9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21E9FE-8EB0-4393-9DC3-0CAEC236D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054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763565-8BE3-4B48-8C81-B8F7986B7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E431D6-047B-4649-9E1F-9DA64C793C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C4457F-A232-4887-9161-62F93D337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11F4E-25F2-4666-9D99-040D44214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5D455B-39C2-42FE-A6B9-92BE50CA9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857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4C8F39-57D5-4AEE-958A-009391B21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87DA18-0C35-44AB-8B8F-95C887C243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A27F65-E108-4679-A70E-9C0A0A1E3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7F83DE-DB83-4824-8BEA-97FA558EFC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04B5D6-78B5-489E-9890-E49E62E7C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288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545C8C-E25D-4888-8FED-BE044499AB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C979FA-7B8B-4BE7-9249-519FA6A52A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FF0BC9-7492-448E-BFAB-4FAE1E19D5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EB8E75-192F-497D-9DB7-6E121871B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A1D0EA-B18F-4675-BFA8-708755DD9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C74230-02A0-47C1-A1CF-32C23CD07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70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D96483-B567-42FB-A735-645A71DAF6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3E5691-FF55-49AB-BA71-B16E29EF47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D4CAFE-8A2C-41F5-94C3-BD656087C4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5C0350-97DC-428F-8A1F-6671CD0649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A322CA-0FAA-49A9-90BF-67BBBB44D0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3968FF-55A2-489B-A0A5-17A832C8E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C7BCCA-E572-40EB-9857-F530669AE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9381FA-95C0-453C-AF36-29001431A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50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99D0CE-31E7-4D52-83BF-0D4EE6EDF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B999B4-8FFB-49F2-8E7C-E0B4ACAAE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264BDB-7132-4BD0-B20D-3D61DD1FB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0F6AB5-453A-4487-A071-027175F9E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491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A72571D-47F4-4231-9973-FF2BD2AD7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795D5E-2649-4DA3-9213-0393F24BB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21EF8E-F354-4A7E-A963-1CE9E5FBC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975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9C7570-02D1-4CED-BBDE-4BF680641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287938-A0C1-4E42-B326-D3F1C847D9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2A49CD-7111-441F-80A2-FD1EDB416C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C3BA18-E1E8-44C8-B4AB-2F09F2CBF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7A71CB-CFDA-4872-B063-B973513A82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05B1B5-F03D-4A55-965B-BDA9E9B24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036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4A0AF5-668B-4067-83CA-B826944D9D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C25538-B18A-4F5A-B330-D53D234CE3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791103-01A1-4F48-8D0F-5B7BC09BA0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E6342E-8893-4BD1-8E37-7EF8A4359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BDD343-FD65-4103-B6E7-63A4A867D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2FC842-6D57-4465-AB95-E9DEE8A24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956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E6D6C8-D4F1-4A9B-B4B2-D3863CDB93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6ABF26-A4C9-405C-91CD-B9EF15F9B7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14B8B3-DB23-45ED-9C45-4AA04A40A2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C0C74-5219-4AD8-8F52-CA6760DD2491}" type="datetimeFigureOut">
              <a:rPr lang="en-US" smtClean="0"/>
              <a:t>2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510760-52F5-4E67-9AAA-2A21483C05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016D20-2C8B-4946-94C2-CB92C3CFD0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1388AA-AF34-41F1-AC42-51A4567FA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jpeg"/><Relationship Id="rId4" Type="http://schemas.openxmlformats.org/officeDocument/2006/relationships/image" Target="../media/image18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bmccancer.biomedcentral.com/articles/10.1186/s12885-019-5723-0#MOESM3" TargetMode="External"/><Relationship Id="rId5" Type="http://schemas.openxmlformats.org/officeDocument/2006/relationships/hyperlink" Target="https://bmccancer.biomedcentral.com/articles/10.1186/s12885-019-5723-0#MOESM1" TargetMode="Externa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.w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7" Type="http://schemas.openxmlformats.org/officeDocument/2006/relationships/hyperlink" Target="http://syslab5.nchu.edu.tw/CircNet/" TargetMode="Externa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w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346DD30-5973-AA4A-A77C-9E4F9D5A0892}"/>
              </a:ext>
            </a:extLst>
          </p:cNvPr>
          <p:cNvSpPr/>
          <p:nvPr/>
        </p:nvSpPr>
        <p:spPr>
          <a:xfrm>
            <a:off x="162692" y="5784265"/>
            <a:ext cx="11241031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8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on 3</a:t>
            </a:r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CACATCTTCATTACCTCCACTAGACTGGCCTTTACCAGCTCATTTTGGACAATGTGAACTGAAAATAGAAGTGCAACCTAAAACTCATCATCGAGCCCATTAPair 1</a:t>
            </a:r>
            <a:r>
              <a:rPr lang="en-US" sz="800" dirty="0"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GAAACTGAAGGTAGCCGAGG</a:t>
            </a:r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GCAGTAAAAGCATCTACTpair 2F</a:t>
            </a:r>
            <a:r>
              <a:rPr lang="en-US" sz="800" dirty="0">
                <a:highlight>
                  <a:srgbClr val="FF00FF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GGGGACATCCTGTTGTGAA</a:t>
            </a:r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600" dirty="0">
                <a:highlight>
                  <a:srgbClr val="00FFFF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#</a:t>
            </a:r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8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cksplice</a:t>
            </a:r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junction)Exon2:ATCTTGAGCCAGATGATTGTGCATCCATTTACATCTTTAATGTAGATCCACCTCCATCTACTTTAACCACACCACTTTGCTTACCACATCATGGATTACCGTCTCACTCTTCTGTTTTGTCACCATCGTTTCAGCTCCAAAGTCACAAAAACTATGAAGGAACTTGTGAGATTCCTGAATCTAAATATApair2R</a:t>
            </a:r>
            <a:r>
              <a:rPr lang="en-US" sz="800" dirty="0">
                <a:highlight>
                  <a:srgbClr val="FF00FF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CCCATTAGGTGGTCCCAAA</a:t>
            </a:r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CCTTTGAGTGCCCAAGTATTCAAATTACATCTATCTCTCCTAACTGTCATCAAGAATTAGATGCACATGAAGATGACCTACAGATAAATGACCCAGAACGGGAATTTTTGGAAAGGCCTTCTAGAGATCATCTCTATCTTCCTCTTGAGCCATCCTACCGGGAGTCTTCTCTTAGTCCTAGTCCTGCCAGCAGCATCTCTTCTAGGAGTTGGTTCTCTGATGCATCTTCTTGTGAATCGCTTTCACATATTTATGATGATGTGGACTCAGAGTTGAATGAAGCTGCAGCCCGATTTACCCTTGGATCCCCTCTGACTTCTCCTGGTGGCTCTCCAGGGGGCTGCCCTGGAGAAGAAACTTGGCATCAACAGTATGGACTTGGACACTCATTATCACCCAGGCAATCTCCTTGCCACTCTCCTAGATCCAGTGTCACTGATGAGAATTGGCTGAGCCCCAGGCCAGCCTCAGGACCCTCATCAAGGCCCACATCCCCCTGTGGGAAACGGAGGCACTCCAGTGCTGAAGTTTGTTATGCTGGGTCCCTTTCACCCCATCACTCACCTGTTCCTTCACCTGGTCACTCCCCCAGGGGAAGTGTGACAGAAGA</a:t>
            </a:r>
            <a:r>
              <a:rPr lang="en-US" sz="800" dirty="0">
                <a:highlight>
                  <a:srgbClr val="FFFF00"/>
                </a:highlight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CGTGGCTCAATGCTTCTGT</a:t>
            </a:r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primer pair1R)CCATGGTGGGTCAGGCCTTGGCCCTGCAGTTTTTCCATTTCAGTACTGTGTAGAGACTGACATCCCTCTCAAAACAAGGAAAACTTCTGAAGATCAAGCTGCCATACTACCAGGAAAAT</a:t>
            </a:r>
            <a:endParaRPr lang="en-QA" sz="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8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GAGCTGTGTTCAGATGACCAAGGGAGTTTATCACCAGCCCGGGAGACTTCAATAGATGATGGCCTTGGATCTCAGTATCCTTTAAAGAAAGATTCATGTGGTGATCAGTTTCTTTCAGTTCCTTCACCCTTTACCTGGAGCAAACCAAAGCCTGGCCACACCCCTATATTTCG    </a:t>
            </a:r>
            <a:endParaRPr lang="en-QA" sz="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5546531-CB52-5240-8C6E-7AA70C7677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0268203"/>
              </p:ext>
            </p:extLst>
          </p:nvPr>
        </p:nvGraphicFramePr>
        <p:xfrm>
          <a:off x="336331" y="315312"/>
          <a:ext cx="9879723" cy="542333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34273">
                  <a:extLst>
                    <a:ext uri="{9D8B030D-6E8A-4147-A177-3AD203B41FA5}">
                      <a16:colId xmlns:a16="http://schemas.microsoft.com/office/drawing/2014/main" val="2124219239"/>
                    </a:ext>
                  </a:extLst>
                </a:gridCol>
                <a:gridCol w="3068519">
                  <a:extLst>
                    <a:ext uri="{9D8B030D-6E8A-4147-A177-3AD203B41FA5}">
                      <a16:colId xmlns:a16="http://schemas.microsoft.com/office/drawing/2014/main" val="199069274"/>
                    </a:ext>
                  </a:extLst>
                </a:gridCol>
                <a:gridCol w="3514312">
                  <a:extLst>
                    <a:ext uri="{9D8B030D-6E8A-4147-A177-3AD203B41FA5}">
                      <a16:colId xmlns:a16="http://schemas.microsoft.com/office/drawing/2014/main" val="1874008453"/>
                    </a:ext>
                  </a:extLst>
                </a:gridCol>
                <a:gridCol w="1262619">
                  <a:extLst>
                    <a:ext uri="{9D8B030D-6E8A-4147-A177-3AD203B41FA5}">
                      <a16:colId xmlns:a16="http://schemas.microsoft.com/office/drawing/2014/main" val="604491758"/>
                    </a:ext>
                  </a:extLst>
                </a:gridCol>
              </a:tblGrid>
              <a:tr h="1531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 Sequenc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sense Sequenc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303303530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-circNFAC3 -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 GUGAAGAUCUUGAGCCAGAUGAUTG 3'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 CAAUCAUCUGGCUCAAGAUCUUCACAA 3'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580722832"/>
                  </a:ext>
                </a:extLst>
              </a:tr>
              <a:tr h="1588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-circNFATC3- 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 GUUGUGAAGAUCUUGAGCCAGAUGA 3'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 UCAUCUGGCUCAAGAUCUUCACAACAG 3'</a:t>
                      </a:r>
                      <a:endParaRPr lang="en-US" sz="800" b="0" i="0" u="none" strike="noStrike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1612677082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3239359869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CRAMBLED circNFAC3 -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 GUGAGGCUCUUGAGCCAGAUGAUTG 3'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 CAAUCAUCUGGCUCAAGAAGCCUCACAA 3'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3040783576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CRAMBLED circNFATC3- 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GUUGUGAGGCUCUUGAGCCAGAUGA 3'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 UCAUCUGGCUCAAGAAGCCUCACAACAG 3'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21529237"/>
                  </a:ext>
                </a:extLst>
              </a:tr>
              <a:tr h="158850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948033858"/>
                  </a:ext>
                </a:extLst>
              </a:tr>
              <a:tr h="18688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-Nfatc3 mRNA-1/silinNFATC3-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CrUrArGrUrCrArArGrArArUrUrUrGrArUrUrCrArGrUrUTT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rArArArCrUrGrArArUrCrArArArUrUrCrUrUrGrArCrUrArGrArG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ctr"/>
                </a:tc>
                <a:tc hMerge="1">
                  <a:txBody>
                    <a:bodyPr/>
                    <a:lstStyle/>
                    <a:p>
                      <a:endParaRPr lang="en-Q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9031687"/>
                  </a:ext>
                </a:extLst>
              </a:tr>
              <a:tr h="17753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-nfatc3mrna-2/silinNFATC3-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rArCrCrArUrUrGrGrUrCrUrGrCrArGrGrArCrArUrCrArCTT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rArGrUrGrArUrGrUrCrCrUrGrCrArGrArCrCrArArUrGrGrUrUrG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 hMerge="1">
                  <a:txBody>
                    <a:bodyPr/>
                    <a:lstStyle/>
                    <a:p>
                      <a:endParaRPr lang="en-Q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9442610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1882500655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 CLONING INTO PCDNA3.1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299685743"/>
                  </a:ext>
                </a:extLst>
              </a:tr>
              <a:tr h="1588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ymes :Ecorv  and Not1</a:t>
                      </a:r>
                      <a:endParaRPr lang="en-US" sz="800" b="1" i="0" u="none" strike="noStrike">
                        <a:solidFill>
                          <a:srgbClr val="33333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443610705"/>
                  </a:ext>
                </a:extLst>
              </a:tr>
              <a:tr h="15885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 CLONING INTO </a:t>
                      </a:r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cRNA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ini vector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ctr"/>
                </a:tc>
                <a:tc hMerge="1">
                  <a:txBody>
                    <a:bodyPr/>
                    <a:lstStyle/>
                    <a:p>
                      <a:endParaRPr lang="en-Q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3960192400"/>
                  </a:ext>
                </a:extLst>
              </a:tr>
              <a:tr h="15886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zymes:EcoRV and Sac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365683239"/>
                  </a:ext>
                </a:extLst>
              </a:tr>
              <a:tr h="1588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umber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Name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s sequenc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 lengt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027142660"/>
                  </a:ext>
                </a:extLst>
              </a:tr>
              <a:tr h="15886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highlight>
                            <a:srgbClr val="FFFF00"/>
                          </a:highlight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r 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cnfatc3 pcr-1-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AACTGAAGGTAGCCGAGG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2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1886158285"/>
                  </a:ext>
                </a:extLst>
              </a:tr>
              <a:tr h="158860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cnfatc3 pcr-1-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GAAGCATTGAGCCACGTA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1017640981"/>
                  </a:ext>
                </a:extLst>
              </a:tr>
              <a:tr h="1681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r 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cnfatc3 pcr-2-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ACTGGGGGACATCCTGTT</a:t>
                      </a:r>
                      <a:endParaRPr lang="en-US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1801173673"/>
                  </a:ext>
                </a:extLst>
              </a:tr>
              <a:tr h="168196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cnfatc3 pcr-2-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GGTAGTATGGCAGCTTGA</a:t>
                      </a:r>
                      <a:endParaRPr lang="en-US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2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431755432"/>
                  </a:ext>
                </a:extLst>
              </a:tr>
              <a:tr h="168196"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-exon2-3-1- 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GTTTATCACCAGCCCG</a:t>
                      </a:r>
                      <a:endParaRPr lang="en-US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2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528500272"/>
                  </a:ext>
                </a:extLst>
              </a:tr>
              <a:tr h="168196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-exon2-3-1- 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AACAGGATGTCCCCCAG</a:t>
                      </a:r>
                      <a:endParaRPr lang="en-US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845369622"/>
                  </a:ext>
                </a:extLst>
              </a:tr>
              <a:tr h="168196"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-exon2-3-2- 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GAGTTTATCACCAGCCC</a:t>
                      </a:r>
                      <a:endParaRPr lang="en-US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1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76891838"/>
                  </a:ext>
                </a:extLst>
              </a:tr>
              <a:tr h="168196"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cnfatc3 pcr-2-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ACTGGGGGACATCCTGT</a:t>
                      </a:r>
                      <a:endParaRPr lang="en-US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4058715573"/>
                  </a:ext>
                </a:extLst>
              </a:tr>
              <a:tr h="158860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cnfatc3 pcr-2-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GTAGTATGGCAGCTTGA</a:t>
                      </a:r>
                      <a:endParaRPr lang="en-US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0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3225561499"/>
                  </a:ext>
                </a:extLst>
              </a:tr>
              <a:tr h="1681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lin-exon-9-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AGCACAAATTTTGATGAAGCA</a:t>
                      </a:r>
                      <a:endParaRPr lang="en-US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1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1588369411"/>
                  </a:ext>
                </a:extLst>
              </a:tr>
              <a:tr h="168196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lin-exon9-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TGTGGCAGATGGGATGAGG</a:t>
                      </a:r>
                      <a:endParaRPr lang="en-US" sz="8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644952494"/>
                  </a:ext>
                </a:extLst>
              </a:tr>
              <a:tr h="1588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lin-exon-9-1-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TCAGGCCTTGGGTAGA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3154531651"/>
                  </a:ext>
                </a:extLst>
              </a:tr>
              <a:tr h="158850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lin-exon9-1-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ACCTCGGAAACAAGAG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Arial Unicode MS" panose="020B0604020202020204" pitchFamily="34" charset="-128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1510600064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078972792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128031088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highlight>
                            <a:srgbClr val="FF00FF"/>
                          </a:highlight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ure 1f,1/primer pair 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00FF"/>
                        </a:highlight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:3:2_G_1_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GGACATCCTGTTGTGA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1747771274"/>
                  </a:ext>
                </a:extLst>
              </a:tr>
              <a:tr h="149506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:13:2_G_1_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TGGGACCACCTAATGGG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510875099"/>
                  </a:ext>
                </a:extLst>
              </a:tr>
              <a:tr h="15886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ure 1f,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-exon2-3-1- 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GTTTATCACCAGCCCG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QA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2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3336990452"/>
                  </a:ext>
                </a:extLst>
              </a:tr>
              <a:tr h="158860">
                <a:tc>
                  <a:txBody>
                    <a:bodyPr/>
                    <a:lstStyle/>
                    <a:p>
                      <a:pPr algn="l" fontAlgn="b"/>
                      <a:endParaRPr lang="en-QA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fatc3-exon2-3-1- 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AACAGGATGTCCCCCAG</a:t>
                      </a:r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7" marR="5627" marT="5627" marB="0" anchor="b"/>
                </a:tc>
                <a:extLst>
                  <a:ext uri="{0D108BD9-81ED-4DB2-BD59-A6C34878D82A}">
                    <a16:rowId xmlns:a16="http://schemas.microsoft.com/office/drawing/2014/main" val="2898848049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76E8FA3-155B-C048-84DD-92F51C393D10}"/>
              </a:ext>
            </a:extLst>
          </p:cNvPr>
          <p:cNvSpPr txBox="1"/>
          <p:nvPr/>
        </p:nvSpPr>
        <p:spPr>
          <a:xfrm>
            <a:off x="3962400" y="0"/>
            <a:ext cx="2371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QA"/>
              <a:t>Suppl</a:t>
            </a:r>
            <a:r>
              <a:rPr lang="en-US" dirty="0"/>
              <a:t>e</a:t>
            </a:r>
            <a:r>
              <a:rPr lang="en-QA"/>
              <a:t>mentary </a:t>
            </a:r>
            <a:r>
              <a:rPr lang="en-QA" dirty="0"/>
              <a:t>Tabl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4EE5EA3-7185-514D-968F-738026714F8A}"/>
              </a:ext>
            </a:extLst>
          </p:cNvPr>
          <p:cNvSpPr txBox="1"/>
          <p:nvPr/>
        </p:nvSpPr>
        <p:spPr>
          <a:xfrm>
            <a:off x="156451" y="5701820"/>
            <a:ext cx="3062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Table 1 C</a:t>
            </a:r>
            <a:r>
              <a:rPr lang="en-QA" sz="1200" dirty="0"/>
              <a:t>ircular RNA sequence</a:t>
            </a:r>
          </a:p>
        </p:txBody>
      </p:sp>
    </p:spTree>
    <p:extLst>
      <p:ext uri="{BB962C8B-B14F-4D97-AF65-F5344CB8AC3E}">
        <p14:creationId xmlns:p14="http://schemas.microsoft.com/office/powerpoint/2010/main" val="22030074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E531C58F-35D3-45A1-B4B0-C0564346AA1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8888533"/>
              </p:ext>
            </p:extLst>
          </p:nvPr>
        </p:nvGraphicFramePr>
        <p:xfrm>
          <a:off x="785916" y="686734"/>
          <a:ext cx="4900078" cy="42835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9464F2C-DDF1-40D8-9B2F-6794B5A740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792862"/>
              </p:ext>
            </p:extLst>
          </p:nvPr>
        </p:nvGraphicFramePr>
        <p:xfrm>
          <a:off x="6287988" y="686734"/>
          <a:ext cx="5350629" cy="42835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1B7B87A-8C10-4ABE-839F-17211CB8A21D}"/>
              </a:ext>
            </a:extLst>
          </p:cNvPr>
          <p:cNvSpPr txBox="1"/>
          <p:nvPr/>
        </p:nvSpPr>
        <p:spPr>
          <a:xfrm rot="16200000">
            <a:off x="90197" y="2534999"/>
            <a:ext cx="1026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OD at 490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731141" y="198706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6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31681" y="5802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892623" y="59217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75643" y="5101084"/>
            <a:ext cx="108861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6 (A) shows proliferation of LCL cells both healthy and TNBC cells that are silenced with circNFATC3 constructs and scrambled control. (B) shows ATP production in similar conditions.</a:t>
            </a:r>
          </a:p>
        </p:txBody>
      </p:sp>
    </p:spTree>
    <p:extLst>
      <p:ext uri="{BB962C8B-B14F-4D97-AF65-F5344CB8AC3E}">
        <p14:creationId xmlns:p14="http://schemas.microsoft.com/office/powerpoint/2010/main" val="18397160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873943C-20DC-454D-ADF4-4A32B98DD598}"/>
              </a:ext>
            </a:extLst>
          </p:cNvPr>
          <p:cNvSpPr/>
          <p:nvPr/>
        </p:nvSpPr>
        <p:spPr>
          <a:xfrm>
            <a:off x="2557058" y="5236458"/>
            <a:ext cx="821501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pplementary Figure 7 shows RNA binding proteins sites matching with circNFATC3 (https://</a:t>
            </a:r>
            <a:r>
              <a:rPr lang="en-US" sz="1200" dirty="0" err="1"/>
              <a:t>circinteractome.nia.nih.gov</a:t>
            </a:r>
            <a:r>
              <a:rPr lang="en-US" sz="1200" dirty="0"/>
              <a:t>).</a:t>
            </a:r>
          </a:p>
        </p:txBody>
      </p:sp>
      <p:pic>
        <p:nvPicPr>
          <p:cNvPr id="6" name="Picture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650DEC27-31A9-4C88-8409-6E5DCA79518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48" r="4212"/>
          <a:stretch/>
        </p:blipFill>
        <p:spPr>
          <a:xfrm>
            <a:off x="2423244" y="615892"/>
            <a:ext cx="7251166" cy="452482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EF4C724-2EE1-4C3B-AD2A-774370AF7A95}"/>
              </a:ext>
            </a:extLst>
          </p:cNvPr>
          <p:cNvSpPr txBox="1"/>
          <p:nvPr/>
        </p:nvSpPr>
        <p:spPr>
          <a:xfrm>
            <a:off x="4679395" y="138449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7 </a:t>
            </a:r>
          </a:p>
        </p:txBody>
      </p:sp>
    </p:spTree>
    <p:extLst>
      <p:ext uri="{BB962C8B-B14F-4D97-AF65-F5344CB8AC3E}">
        <p14:creationId xmlns:p14="http://schemas.microsoft.com/office/powerpoint/2010/main" val="1369213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7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dirty="0"/>
          </a:p>
        </p:txBody>
      </p:sp>
      <p:sp>
        <p:nvSpPr>
          <p:cNvPr id="8" name="Rectangle 11"/>
          <p:cNvSpPr>
            <a:spLocks noChangeArrowheads="1"/>
          </p:cNvSpPr>
          <p:nvPr/>
        </p:nvSpPr>
        <p:spPr bwMode="auto">
          <a:xfrm>
            <a:off x="0" y="780097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9" name="Rectangle 12"/>
          <p:cNvSpPr>
            <a:spLocks noChangeArrowheads="1"/>
          </p:cNvSpPr>
          <p:nvPr/>
        </p:nvSpPr>
        <p:spPr bwMode="auto">
          <a:xfrm>
            <a:off x="0" y="929640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16" name="Group 15"/>
          <p:cNvGrpSpPr/>
          <p:nvPr/>
        </p:nvGrpSpPr>
        <p:grpSpPr>
          <a:xfrm>
            <a:off x="96715" y="156813"/>
            <a:ext cx="12253547" cy="6526807"/>
            <a:chOff x="0" y="174397"/>
            <a:chExt cx="12253547" cy="6526807"/>
          </a:xfrm>
        </p:grpSpPr>
        <p:grpSp>
          <p:nvGrpSpPr>
            <p:cNvPr id="10" name="Group 9"/>
            <p:cNvGrpSpPr/>
            <p:nvPr/>
          </p:nvGrpSpPr>
          <p:grpSpPr>
            <a:xfrm>
              <a:off x="607862" y="3200400"/>
              <a:ext cx="9607061" cy="3500804"/>
              <a:chOff x="266700" y="2561125"/>
              <a:chExt cx="10435737" cy="4070472"/>
            </a:xfrm>
          </p:grpSpPr>
          <p:pic>
            <p:nvPicPr>
              <p:cNvPr id="3078" name="Picture 1"/>
              <p:cNvPicPr>
                <a:picLocks noChangeAspect="1" noChangeArrowheads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6700" y="2581275"/>
                <a:ext cx="5191125" cy="12382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077" name="Picture 6"/>
              <p:cNvPicPr>
                <a:picLocks noChangeAspect="1" noChangeArrowheads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530362" y="2561125"/>
                <a:ext cx="5172075" cy="12763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076" name="Picture 7"/>
              <p:cNvPicPr>
                <a:picLocks noChangeAspect="1" noChangeArrowheads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6700" y="4068273"/>
                <a:ext cx="5048250" cy="12287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075" name="Picture 9"/>
              <p:cNvPicPr>
                <a:picLocks noChangeAspect="1" noChangeArrowheads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57825" y="4043362"/>
                <a:ext cx="5244612" cy="12287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074" name="Picture 10"/>
              <p:cNvPicPr>
                <a:picLocks noChangeAspect="1" noChangeArrowheads="1"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6700" y="5479072"/>
                <a:ext cx="4924425" cy="11525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073" name="Picture 11"/>
              <p:cNvPicPr>
                <a:picLocks noChangeAspect="1" noChangeArrowheads="1"/>
              </p:cNvPicPr>
              <p:nvPr/>
            </p:nvPicPr>
            <p:blipFill>
              <a:blip r:embed="rId7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41339" y="5451962"/>
                <a:ext cx="5261098" cy="116937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5" name="Rectangle 8"/>
            <p:cNvSpPr>
              <a:spLocks noChangeArrowheads="1"/>
            </p:cNvSpPr>
            <p:nvPr/>
          </p:nvSpPr>
          <p:spPr bwMode="auto">
            <a:xfrm>
              <a:off x="0" y="3015734"/>
              <a:ext cx="309700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6" name="Rectangle 9"/>
            <p:cNvSpPr>
              <a:spLocks noChangeArrowheads="1"/>
            </p:cNvSpPr>
            <p:nvPr/>
          </p:nvSpPr>
          <p:spPr bwMode="auto">
            <a:xfrm>
              <a:off x="61547" y="4233922"/>
              <a:ext cx="12192000" cy="457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US"/>
            </a:p>
          </p:txBody>
        </p:sp>
        <p:sp>
          <p:nvSpPr>
            <p:cNvPr id="7" name="Rectangle 10"/>
            <p:cNvSpPr>
              <a:spLocks noChangeArrowheads="1"/>
            </p:cNvSpPr>
            <p:nvPr/>
          </p:nvSpPr>
          <p:spPr bwMode="auto">
            <a:xfrm>
              <a:off x="0" y="6191250"/>
              <a:ext cx="12192000" cy="457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US"/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184" y="174397"/>
              <a:ext cx="2909728" cy="275587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4481716" y="190641"/>
              <a:ext cx="24717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upplementary Figure 8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46108" y="3203419"/>
              <a:ext cx="7737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xon2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704385" y="5439084"/>
              <a:ext cx="5629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exon3</a:t>
              </a:r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>
              <a:off x="8739555" y="5472078"/>
              <a:ext cx="0" cy="383598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3644160" y="1062973"/>
              <a:ext cx="7675684" cy="830997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dirty="0"/>
                <a:t>Gel picture explaining the vectors both cut and uncut. Left panel shows PCDNA3.1+alu vector and pcDNA3.1 control vectors both cut and uncut along with reference PAVAE vector, its size is known. Right panel represents both PCDNA3.1 with </a:t>
              </a:r>
              <a:r>
                <a:rPr lang="en-US" sz="1200" dirty="0" err="1"/>
                <a:t>alu</a:t>
              </a:r>
              <a:r>
                <a:rPr lang="en-US" sz="1200" dirty="0"/>
                <a:t> and PCDNA3.1 vector with NFATC3 exon 2 and 3 insert. (Enzymes used for digestion are </a:t>
              </a:r>
              <a:r>
                <a:rPr lang="en-US" sz="1200" dirty="0" err="1"/>
                <a:t>EcoRV</a:t>
              </a:r>
              <a:r>
                <a:rPr lang="en-US" sz="1200" dirty="0"/>
                <a:t> and </a:t>
              </a:r>
              <a:r>
                <a:rPr lang="en-US" sz="1200" dirty="0" err="1"/>
                <a:t>Sacll</a:t>
              </a:r>
              <a:r>
                <a:rPr lang="en-US" sz="1200" dirty="0"/>
                <a:t> for </a:t>
              </a:r>
              <a:r>
                <a:rPr lang="en-US" sz="1200" dirty="0" err="1"/>
                <a:t>circRNA</a:t>
              </a:r>
              <a:r>
                <a:rPr lang="en-US" sz="1200" dirty="0"/>
                <a:t> </a:t>
              </a:r>
              <a:r>
                <a:rPr lang="en-US" sz="1200" dirty="0" err="1"/>
                <a:t>minivector</a:t>
              </a:r>
              <a:r>
                <a:rPr lang="en-US" sz="1200" dirty="0"/>
                <a:t> pcDNA3.1+alu  and </a:t>
              </a:r>
              <a:r>
                <a:rPr lang="en-US" sz="1200" dirty="0" err="1"/>
                <a:t>EcoRV</a:t>
              </a:r>
              <a:r>
                <a:rPr lang="en-US" sz="1200" dirty="0"/>
                <a:t>  and Not1 for PCDNA3.1)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26184" y="2243354"/>
              <a:ext cx="18008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4">
                      <a:lumMod val="60000"/>
                      <a:lumOff val="40000"/>
                    </a:schemeClr>
                  </a:solidFill>
                </a:rPr>
                <a:t>Empty vectors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79492" y="2278568"/>
              <a:ext cx="148810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accent4">
                      <a:lumMod val="60000"/>
                      <a:lumOff val="40000"/>
                    </a:schemeClr>
                  </a:solidFill>
                </a:rPr>
                <a:t>Vector with </a:t>
              </a:r>
            </a:p>
            <a:p>
              <a:r>
                <a:rPr lang="en-US" sz="1200" dirty="0">
                  <a:solidFill>
                    <a:schemeClr val="accent4">
                      <a:lumMod val="60000"/>
                      <a:lumOff val="40000"/>
                    </a:schemeClr>
                  </a:solidFill>
                </a:rPr>
                <a:t>NFATC3 exon 2 and3 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0" y="624564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035669" y="2760758"/>
              <a:ext cx="40566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anger Sequencing (NFATC3 exon2 and 3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2853426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Chart, radar chart&#10;&#10;Description automatically generated">
            <a:extLst>
              <a:ext uri="{FF2B5EF4-FFF2-40B4-BE49-F238E27FC236}">
                <a16:creationId xmlns:a16="http://schemas.microsoft.com/office/drawing/2014/main" id="{29C89F4A-233E-4F94-B991-53ED10580B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855" y="3754010"/>
            <a:ext cx="3260034" cy="2286021"/>
          </a:xfrm>
          <a:prstGeom prst="rect">
            <a:avLst/>
          </a:prstGeom>
        </p:spPr>
      </p:pic>
      <p:pic>
        <p:nvPicPr>
          <p:cNvPr id="11" name="Picture 10" descr="Chart&#10;&#10;Description automatically generated">
            <a:extLst>
              <a:ext uri="{FF2B5EF4-FFF2-40B4-BE49-F238E27FC236}">
                <a16:creationId xmlns:a16="http://schemas.microsoft.com/office/drawing/2014/main" id="{9F732CC8-CD5F-4CE4-BE69-28BECD1C996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115" y="0"/>
            <a:ext cx="3988859" cy="3550070"/>
          </a:xfrm>
          <a:prstGeom prst="rect">
            <a:avLst/>
          </a:prstGeom>
        </p:spPr>
      </p:pic>
      <p:pic>
        <p:nvPicPr>
          <p:cNvPr id="13" name="Picture 12" descr="Chart, radar chart&#10;&#10;Description automatically generated">
            <a:extLst>
              <a:ext uri="{FF2B5EF4-FFF2-40B4-BE49-F238E27FC236}">
                <a16:creationId xmlns:a16="http://schemas.microsoft.com/office/drawing/2014/main" id="{B93A4938-0595-4DC7-A18C-3E8CB3D2C14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8946" y="384984"/>
            <a:ext cx="7248939" cy="3254538"/>
          </a:xfrm>
          <a:prstGeom prst="rect">
            <a:avLst/>
          </a:prstGeom>
        </p:spPr>
      </p:pic>
      <p:pic>
        <p:nvPicPr>
          <p:cNvPr id="15" name="Picture 14" descr="Chart, radar chart&#10;&#10;Description automatically generated">
            <a:extLst>
              <a:ext uri="{FF2B5EF4-FFF2-40B4-BE49-F238E27FC236}">
                <a16:creationId xmlns:a16="http://schemas.microsoft.com/office/drawing/2014/main" id="{2780C269-F244-4AF6-A765-E7E517E0636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3754010"/>
            <a:ext cx="3677614" cy="285323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259C31B6-3230-4DFC-983D-ED0CCBD68969}"/>
              </a:ext>
            </a:extLst>
          </p:cNvPr>
          <p:cNvSpPr txBox="1"/>
          <p:nvPr/>
        </p:nvSpPr>
        <p:spPr>
          <a:xfrm>
            <a:off x="4578431" y="17305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9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D848BC-B43F-43E2-BBDF-3ABD0AEA4F20}"/>
              </a:ext>
            </a:extLst>
          </p:cNvPr>
          <p:cNvSpPr txBox="1"/>
          <p:nvPr/>
        </p:nvSpPr>
        <p:spPr>
          <a:xfrm>
            <a:off x="424116" y="6315696"/>
            <a:ext cx="98662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PA analysis shows various gene networks involved in cell to cell contact, growth arrest, cell movement,</a:t>
            </a:r>
          </a:p>
          <a:p>
            <a:r>
              <a:rPr lang="en-US" sz="1200" dirty="0"/>
              <a:t> inflammation and proliferation</a:t>
            </a:r>
          </a:p>
        </p:txBody>
      </p:sp>
    </p:spTree>
    <p:extLst>
      <p:ext uri="{BB962C8B-B14F-4D97-AF65-F5344CB8AC3E}">
        <p14:creationId xmlns:p14="http://schemas.microsoft.com/office/powerpoint/2010/main" val="10892036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5739263"/>
              </p:ext>
            </p:extLst>
          </p:nvPr>
        </p:nvGraphicFramePr>
        <p:xfrm>
          <a:off x="2448744" y="970280"/>
          <a:ext cx="3331569" cy="24478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1054294"/>
              </p:ext>
            </p:extLst>
          </p:nvPr>
        </p:nvGraphicFramePr>
        <p:xfrm>
          <a:off x="5967293" y="948621"/>
          <a:ext cx="3483099" cy="24807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5564128" y="2000570"/>
            <a:ext cx="11531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Fold Expression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844836" y="172356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**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158666" y="122071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a typeface="Arial" charset="0"/>
                <a:cs typeface="Arial" charset="0"/>
              </a:rPr>
              <a:t>**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477974" y="3368018"/>
            <a:ext cx="926904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a typeface="Arial" charset="0"/>
                <a:cs typeface="Arial" charset="0"/>
              </a:rPr>
              <a:t>Supplementary Figure 1 -The (A) Purity of cytoplasmic fraction. </a:t>
            </a:r>
            <a:r>
              <a:rPr lang="en-US" sz="1200" dirty="0" err="1">
                <a:ea typeface="Arial" charset="0"/>
                <a:cs typeface="Arial" charset="0"/>
              </a:rPr>
              <a:t>qRT</a:t>
            </a:r>
            <a:r>
              <a:rPr lang="en-US" sz="1200" dirty="0">
                <a:ea typeface="Arial" charset="0"/>
                <a:cs typeface="Arial" charset="0"/>
              </a:rPr>
              <a:t>-PCR data shows positive control marker for cytoplasmic fraction, whereas 18s rRNA displays minimal expression in the nuclear fraction. (B) Purity of nuclear fraction. </a:t>
            </a:r>
            <a:r>
              <a:rPr lang="en-US" sz="1200" dirty="0" err="1">
                <a:ea typeface="Arial" charset="0"/>
                <a:cs typeface="Arial" charset="0"/>
              </a:rPr>
              <a:t>qRT</a:t>
            </a:r>
            <a:r>
              <a:rPr lang="en-US" sz="1200" dirty="0">
                <a:ea typeface="Arial" charset="0"/>
                <a:cs typeface="Arial" charset="0"/>
              </a:rPr>
              <a:t>-PCR data shows positive control marker for nuclear fraction, whereas snRNAU1 displays minimal expression in the cytoplasmic fraction. Data in S2:8 are the means SEM of three experiments. **</a:t>
            </a:r>
            <a:r>
              <a:rPr lang="en-US" sz="1200" i="1" dirty="0">
                <a:ea typeface="Arial" charset="0"/>
                <a:cs typeface="Arial" charset="0"/>
              </a:rPr>
              <a:t>P</a:t>
            </a:r>
            <a:r>
              <a:rPr lang="en-US" sz="1200" dirty="0">
                <a:ea typeface="Arial" charset="0"/>
                <a:cs typeface="Arial" charset="0"/>
              </a:rPr>
              <a:t>&lt;0.01 (Student’s </a:t>
            </a:r>
            <a:r>
              <a:rPr lang="en-US" sz="1200" i="1" dirty="0">
                <a:ea typeface="Arial" charset="0"/>
                <a:cs typeface="Arial" charset="0"/>
              </a:rPr>
              <a:t>t</a:t>
            </a:r>
            <a:r>
              <a:rPr lang="en-US" sz="1200" dirty="0">
                <a:ea typeface="Arial" charset="0"/>
                <a:cs typeface="Arial" charset="0"/>
              </a:rPr>
              <a:t>-test)</a:t>
            </a:r>
          </a:p>
          <a:p>
            <a:r>
              <a:rPr lang="en-US" sz="1200" dirty="0">
                <a:ea typeface="Arial" charset="0"/>
                <a:cs typeface="Arial" charset="0"/>
              </a:rPr>
              <a:t>Figure Adapted from </a:t>
            </a:r>
            <a:r>
              <a:rPr lang="en-US" sz="1200" b="1" dirty="0"/>
              <a:t>(Additional file </a:t>
            </a:r>
            <a:r>
              <a:rPr lang="en-US" sz="1200" b="1" u="sng" dirty="0">
                <a:hlinkClick r:id="rId5"/>
              </a:rPr>
              <a:t>1</a:t>
            </a:r>
            <a:r>
              <a:rPr lang="en-US" sz="1200" b="1" dirty="0"/>
              <a:t>: Figure S1: Fig a, b, Additional file </a:t>
            </a:r>
            <a:r>
              <a:rPr lang="en-US" sz="1200" b="1" u="sng" dirty="0">
                <a:hlinkClick r:id="rId6"/>
              </a:rPr>
              <a:t>3</a:t>
            </a:r>
            <a:r>
              <a:rPr lang="en-US" sz="1200" b="1" dirty="0"/>
              <a:t>: S2:8).</a:t>
            </a:r>
            <a:r>
              <a:rPr lang="en-US" sz="1200" b="1" dirty="0">
                <a:ea typeface="Arial" charset="0"/>
                <a:cs typeface="Arial" charset="0"/>
              </a:rPr>
              <a:t> </a:t>
            </a:r>
            <a:r>
              <a:rPr lang="en-US" sz="1200" dirty="0" err="1"/>
              <a:t>Karedath</a:t>
            </a:r>
            <a:r>
              <a:rPr lang="en-US" sz="1200" dirty="0"/>
              <a:t>, T., Ahmed, I., Al Ameri, W. </a:t>
            </a:r>
            <a:r>
              <a:rPr lang="en-US" sz="1200" i="1" dirty="0"/>
              <a:t>et al.</a:t>
            </a:r>
            <a:r>
              <a:rPr lang="en-US" sz="1200" dirty="0"/>
              <a:t> Silencing of ANKRD12 </a:t>
            </a:r>
            <a:r>
              <a:rPr lang="en-US" sz="1200" dirty="0" err="1"/>
              <a:t>circRNA</a:t>
            </a:r>
            <a:r>
              <a:rPr lang="en-US" sz="1200" dirty="0"/>
              <a:t> induces molecular and functional changes associated with invasive phenotypes. </a:t>
            </a:r>
            <a:r>
              <a:rPr lang="en-US" sz="1200" i="1" dirty="0"/>
              <a:t>BMC Cancer</a:t>
            </a:r>
            <a:r>
              <a:rPr lang="en-US" sz="1200" dirty="0"/>
              <a:t> 19, 565 (2019). https://</a:t>
            </a:r>
            <a:r>
              <a:rPr lang="en-US" sz="1200" dirty="0" err="1"/>
              <a:t>doi.org</a:t>
            </a:r>
            <a:r>
              <a:rPr lang="en-US" sz="1200" dirty="0"/>
              <a:t>/10.1186/s12885-019-5723-0</a:t>
            </a:r>
            <a:endParaRPr lang="en-US" sz="1200" dirty="0"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82237" y="922989"/>
            <a:ext cx="404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684069" y="912156"/>
            <a:ext cx="406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10896" y="464178"/>
            <a:ext cx="4141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ea typeface="Arial" charset="0"/>
                <a:cs typeface="Arial" charset="0"/>
              </a:rPr>
              <a:t>Purity of cytoplasmic and nuclear fraction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A51A884-2AF2-994C-8E21-071C565469F5}"/>
              </a:ext>
            </a:extLst>
          </p:cNvPr>
          <p:cNvSpPr/>
          <p:nvPr/>
        </p:nvSpPr>
        <p:spPr>
          <a:xfrm>
            <a:off x="4080633" y="93111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QA"/>
              <a:t>Suppl</a:t>
            </a:r>
            <a:r>
              <a:rPr lang="en-US" dirty="0"/>
              <a:t>e</a:t>
            </a:r>
            <a:r>
              <a:rPr lang="en-QA"/>
              <a:t>mentary </a:t>
            </a:r>
            <a:r>
              <a:rPr lang="en-QA" dirty="0"/>
              <a:t>Figure 1</a:t>
            </a:r>
          </a:p>
        </p:txBody>
      </p:sp>
    </p:spTree>
    <p:extLst>
      <p:ext uri="{BB962C8B-B14F-4D97-AF65-F5344CB8AC3E}">
        <p14:creationId xmlns:p14="http://schemas.microsoft.com/office/powerpoint/2010/main" val="1231629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E4EDD4D-485A-9A45-BEB7-19936A13C6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1305" y="572178"/>
            <a:ext cx="9205018" cy="26815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9F34AFD-A4E4-824C-861B-15286446C5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41305" y="3253696"/>
            <a:ext cx="9205018" cy="26963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3873546" y="147376"/>
            <a:ext cx="2384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Table 2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41305" y="644476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835160" y="6014125"/>
            <a:ext cx="9311163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Table 2 shows predicted activation or down regulation of function and genes involved  in siRNA-mediated circNFATC3 silenced cells compared to scrambled control. IPA (ingenuity pathway analysis of differentially regulated genes in circNFATC3 silenced MDA-MB-231 cells vs. control). (A) shows predicted downregulation of cellular movement whereas (B) shows downregulation of lipid synthesis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51311" y="50441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38935" y="319638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611712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6119" y="114718"/>
            <a:ext cx="2384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Table 2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4655" y="527594"/>
            <a:ext cx="9134475" cy="34766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825615" y="43082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8" name="Rectangle 7"/>
          <p:cNvSpPr/>
          <p:nvPr/>
        </p:nvSpPr>
        <p:spPr>
          <a:xfrm>
            <a:off x="1107073" y="4135065"/>
            <a:ext cx="923354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pplementary Table 2 shows predicted activation or down regulation of function and genes involved  in siRNA-mediated circNFATC3 silenced cells compared to scrambled control.  IPA (ingenuity pathway analysis of differentially regulated genes in circNFATC3 silenced  MDA-MB-231 cells vs. control) (C) shows that the growth and proliferation of tumor is decreased.</a:t>
            </a:r>
          </a:p>
        </p:txBody>
      </p:sp>
    </p:spTree>
    <p:extLst>
      <p:ext uri="{BB962C8B-B14F-4D97-AF65-F5344CB8AC3E}">
        <p14:creationId xmlns:p14="http://schemas.microsoft.com/office/powerpoint/2010/main" val="26201901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143A770-3C33-4732-9E5B-3E4CCA4E9D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7789689"/>
              </p:ext>
            </p:extLst>
          </p:nvPr>
        </p:nvGraphicFramePr>
        <p:xfrm>
          <a:off x="2032318" y="686762"/>
          <a:ext cx="7119937" cy="3998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40" name="Image" r:id="rId3" imgW="7120080" imgH="3998880" progId="Photoshop.Image.18">
                  <p:embed/>
                </p:oleObj>
              </mc:Choice>
              <mc:Fallback>
                <p:oleObj name="Image" r:id="rId3" imgW="7120080" imgH="3998880" progId="Photoshop.Image.18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32318" y="686762"/>
                        <a:ext cx="7119937" cy="399891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112833" y="21101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811806" y="4822745"/>
            <a:ext cx="7593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2 Real-time validation of circNFATC3 silenced SKOV3 and MDA-MB-231 cells compared to control. Four genes differentially regulated in circNFATC3 silenced cells and its control are validated.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1388097" y="2759473"/>
            <a:ext cx="18104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elative Expression (Log2)</a:t>
            </a:r>
          </a:p>
        </p:txBody>
      </p:sp>
    </p:spTree>
    <p:extLst>
      <p:ext uri="{BB962C8B-B14F-4D97-AF65-F5344CB8AC3E}">
        <p14:creationId xmlns:p14="http://schemas.microsoft.com/office/powerpoint/2010/main" val="34906656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657872" y="1449819"/>
            <a:ext cx="6283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ontro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23083" y="146985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125793" y="5437832"/>
            <a:ext cx="67807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3 (A) Mitochondrial respiration measured by oxidation consumption rate (OCR) (</a:t>
            </a:r>
            <a:r>
              <a:rPr lang="en-US" sz="1200" dirty="0" err="1"/>
              <a:t>pmol</a:t>
            </a:r>
            <a:r>
              <a:rPr lang="en-US" sz="1200" dirty="0"/>
              <a:t>/min) in SKOV3 cell line (si-circNFATC3 vs control) using Seahorse XF96 analyzer. Control (green) shows a higher OCR compared to two constructs of siRNA used for silencing circNFATC3 (orange and red)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42A7674-F961-FB4B-B8E2-F15003DE1259}"/>
              </a:ext>
            </a:extLst>
          </p:cNvPr>
          <p:cNvSpPr txBox="1"/>
          <p:nvPr/>
        </p:nvSpPr>
        <p:spPr>
          <a:xfrm>
            <a:off x="2299967" y="633184"/>
            <a:ext cx="731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graphicFrame>
        <p:nvGraphicFramePr>
          <p:cNvPr id="7" name="BigChart">
            <a:extLst>
              <a:ext uri="{FF2B5EF4-FFF2-40B4-BE49-F238E27FC236}">
                <a16:creationId xmlns:a16="http://schemas.microsoft.com/office/drawing/2014/main" id="{DFE70B61-9A6D-0A47-8253-E4B07439CF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1617858"/>
              </p:ext>
            </p:extLst>
          </p:nvPr>
        </p:nvGraphicFramePr>
        <p:xfrm>
          <a:off x="1378635" y="553037"/>
          <a:ext cx="7158696" cy="53035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290447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BigChart">
            <a:extLst>
              <a:ext uri="{FF2B5EF4-FFF2-40B4-BE49-F238E27FC236}">
                <a16:creationId xmlns:a16="http://schemas.microsoft.com/office/drawing/2014/main" id="{00000000-0008-0000-0400-00000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5746642"/>
              </p:ext>
            </p:extLst>
          </p:nvPr>
        </p:nvGraphicFramePr>
        <p:xfrm>
          <a:off x="507891" y="636819"/>
          <a:ext cx="6134956" cy="3852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SubChart2">
            <a:extLst>
              <a:ext uri="{FF2B5EF4-FFF2-40B4-BE49-F238E27FC236}">
                <a16:creationId xmlns:a16="http://schemas.microsoft.com/office/drawing/2014/main" id="{00000000-0008-0000-0400-00001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9279982"/>
              </p:ext>
            </p:extLst>
          </p:nvPr>
        </p:nvGraphicFramePr>
        <p:xfrm>
          <a:off x="7055829" y="787999"/>
          <a:ext cx="4709343" cy="33967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AA8F9EA-A322-534F-9889-0D642C6B5E35}"/>
              </a:ext>
            </a:extLst>
          </p:cNvPr>
          <p:cNvSpPr txBox="1"/>
          <p:nvPr/>
        </p:nvSpPr>
        <p:spPr>
          <a:xfrm>
            <a:off x="5200651" y="804383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ircular mini vector+ alu+NFATC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5D85F56-E065-9949-A04D-B4C0FFADD1FC}"/>
              </a:ext>
            </a:extLst>
          </p:cNvPr>
          <p:cNvSpPr txBox="1"/>
          <p:nvPr/>
        </p:nvSpPr>
        <p:spPr>
          <a:xfrm>
            <a:off x="5191125" y="1095056"/>
            <a:ext cx="11049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Empty vector+ </a:t>
            </a:r>
            <a:r>
              <a:rPr lang="en-US" sz="900" dirty="0" err="1"/>
              <a:t>alu</a:t>
            </a:r>
            <a:endParaRPr lang="en-US" sz="9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5A4B7E5-11F9-9B46-84B1-6A08C8D38B93}"/>
              </a:ext>
            </a:extLst>
          </p:cNvPr>
          <p:cNvSpPr txBox="1"/>
          <p:nvPr/>
        </p:nvSpPr>
        <p:spPr>
          <a:xfrm>
            <a:off x="5177360" y="1252556"/>
            <a:ext cx="1173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Empty PCDNA3.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D07668-7461-0749-BA61-8268103CB989}"/>
              </a:ext>
            </a:extLst>
          </p:cNvPr>
          <p:cNvSpPr txBox="1"/>
          <p:nvPr/>
        </p:nvSpPr>
        <p:spPr>
          <a:xfrm>
            <a:off x="5181601" y="1524506"/>
            <a:ext cx="11498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PCDNA3.1+NFATC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949608" y="4596702"/>
            <a:ext cx="105944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3 (B) Mitochondrial respiration analysis of over-expressed circNFATC3 SKOV3 cells and its control conditions (empty </a:t>
            </a:r>
            <a:r>
              <a:rPr lang="en-US" sz="1200" dirty="0" err="1"/>
              <a:t>vector+alu</a:t>
            </a:r>
            <a:r>
              <a:rPr lang="en-US" sz="1200" dirty="0"/>
              <a:t>, empty PCDNA3.1, PCDN3.1+NFATC3). Over-expression of circles in </a:t>
            </a:r>
            <a:r>
              <a:rPr lang="en-US" sz="1200" dirty="0" err="1"/>
              <a:t>circRNA</a:t>
            </a:r>
            <a:r>
              <a:rPr lang="en-US" sz="1200" dirty="0"/>
              <a:t> mini-vector shows reversal of phenotype while knocking down the circNFATC3.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02365" y="131180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94B9865-8469-F642-B62B-E346AF355D17}"/>
              </a:ext>
            </a:extLst>
          </p:cNvPr>
          <p:cNvSpPr txBox="1"/>
          <p:nvPr/>
        </p:nvSpPr>
        <p:spPr>
          <a:xfrm>
            <a:off x="190574" y="503368"/>
            <a:ext cx="406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0852571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1DBAD09-D433-3F46-BF1E-7606F5DE229E}"/>
              </a:ext>
            </a:extLst>
          </p:cNvPr>
          <p:cNvSpPr txBox="1"/>
          <p:nvPr/>
        </p:nvSpPr>
        <p:spPr>
          <a:xfrm>
            <a:off x="4979370" y="171131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4</a:t>
            </a:r>
          </a:p>
        </p:txBody>
      </p:sp>
      <p:graphicFrame>
        <p:nvGraphicFramePr>
          <p:cNvPr id="5" name="OCR Chart">
            <a:extLst>
              <a:ext uri="{FF2B5EF4-FFF2-40B4-BE49-F238E27FC236}">
                <a16:creationId xmlns:a16="http://schemas.microsoft.com/office/drawing/2014/main" id="{00000000-0008-0000-0B00-00000E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1447394"/>
              </p:ext>
            </p:extLst>
          </p:nvPr>
        </p:nvGraphicFramePr>
        <p:xfrm>
          <a:off x="6232485" y="400461"/>
          <a:ext cx="5113073" cy="51924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ScatterChart">
            <a:extLst>
              <a:ext uri="{FF2B5EF4-FFF2-40B4-BE49-F238E27FC236}">
                <a16:creationId xmlns:a16="http://schemas.microsoft.com/office/drawing/2014/main" id="{00000000-0008-0000-0B00-00000B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8477308"/>
              </p:ext>
            </p:extLst>
          </p:nvPr>
        </p:nvGraphicFramePr>
        <p:xfrm>
          <a:off x="1235406" y="525437"/>
          <a:ext cx="5675313" cy="5206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466557" y="4901586"/>
            <a:ext cx="96789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ry Figure 4 Energy phenotype measured by Seahorse Flux analyzer in SKOV3 cells over-expressed with circNFATC3 construct and its controls. Cell energy phenotype shows circNFATC3 over-expressed circles are more aerobic and more energetic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AA8F9EA-A322-534F-9889-0D642C6B5E35}"/>
              </a:ext>
            </a:extLst>
          </p:cNvPr>
          <p:cNvSpPr txBox="1"/>
          <p:nvPr/>
        </p:nvSpPr>
        <p:spPr>
          <a:xfrm>
            <a:off x="3020928" y="4552034"/>
            <a:ext cx="18165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ircular mini vector+alu+nfatc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D85F56-E065-9949-A04D-B4C0FFADD1FC}"/>
              </a:ext>
            </a:extLst>
          </p:cNvPr>
          <p:cNvSpPr txBox="1"/>
          <p:nvPr/>
        </p:nvSpPr>
        <p:spPr>
          <a:xfrm>
            <a:off x="5214733" y="4556488"/>
            <a:ext cx="11288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Empty vector+ </a:t>
            </a:r>
            <a:r>
              <a:rPr lang="en-US" sz="1000" dirty="0" err="1"/>
              <a:t>alu</a:t>
            </a:r>
            <a:endParaRPr lang="en-US" sz="1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5A4B7E5-11F9-9B46-84B1-6A08C8D38B93}"/>
              </a:ext>
            </a:extLst>
          </p:cNvPr>
          <p:cNvSpPr txBox="1"/>
          <p:nvPr/>
        </p:nvSpPr>
        <p:spPr>
          <a:xfrm>
            <a:off x="6806428" y="4551979"/>
            <a:ext cx="1080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Empty PCDNA3.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3D07668-7461-0749-BA61-8268103CB989}"/>
              </a:ext>
            </a:extLst>
          </p:cNvPr>
          <p:cNvSpPr txBox="1"/>
          <p:nvPr/>
        </p:nvSpPr>
        <p:spPr>
          <a:xfrm>
            <a:off x="8328628" y="4557176"/>
            <a:ext cx="11961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CDNA3.1+NFATC3</a:t>
            </a:r>
          </a:p>
        </p:txBody>
      </p:sp>
      <p:sp>
        <p:nvSpPr>
          <p:cNvPr id="13" name="Rectangle 12"/>
          <p:cNvSpPr/>
          <p:nvPr/>
        </p:nvSpPr>
        <p:spPr>
          <a:xfrm>
            <a:off x="2872138" y="4623490"/>
            <a:ext cx="177942" cy="115416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4" name="Rectangle 13"/>
          <p:cNvSpPr/>
          <p:nvPr/>
        </p:nvSpPr>
        <p:spPr>
          <a:xfrm>
            <a:off x="5062551" y="4614216"/>
            <a:ext cx="177942" cy="11541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5" name="Rectangle 14"/>
          <p:cNvSpPr/>
          <p:nvPr/>
        </p:nvSpPr>
        <p:spPr>
          <a:xfrm>
            <a:off x="6654646" y="4603173"/>
            <a:ext cx="177942" cy="115416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6" name="Rectangle 15"/>
          <p:cNvSpPr/>
          <p:nvPr/>
        </p:nvSpPr>
        <p:spPr>
          <a:xfrm>
            <a:off x="8178928" y="4612146"/>
            <a:ext cx="177942" cy="115416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</p:spTree>
    <p:extLst>
      <p:ext uri="{BB962C8B-B14F-4D97-AF65-F5344CB8AC3E}">
        <p14:creationId xmlns:p14="http://schemas.microsoft.com/office/powerpoint/2010/main" val="40283512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1A2C765-60D0-4F3B-9651-4972F90403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0914210"/>
              </p:ext>
            </p:extLst>
          </p:nvPr>
        </p:nvGraphicFramePr>
        <p:xfrm>
          <a:off x="5734373" y="789478"/>
          <a:ext cx="6020647" cy="5032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2" name="Image" r:id="rId3" imgW="3047760" imgH="2072520" progId="Photoshop.Image.18">
                  <p:embed/>
                </p:oleObj>
              </mc:Choice>
              <mc:Fallback>
                <p:oleObj name="Image" r:id="rId3" imgW="3047760" imgH="2072520" progId="Photoshop.Image.18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734373" y="789478"/>
                        <a:ext cx="6020647" cy="503287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4260C7D-AE16-4768-BF14-F8673FE869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0746080"/>
              </p:ext>
            </p:extLst>
          </p:nvPr>
        </p:nvGraphicFramePr>
        <p:xfrm>
          <a:off x="436980" y="789478"/>
          <a:ext cx="5021285" cy="50328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3" name="Image" r:id="rId5" imgW="3508200" imgH="3587400" progId="Photoshop.Image.18">
                  <p:embed/>
                </p:oleObj>
              </mc:Choice>
              <mc:Fallback>
                <p:oleObj name="Image" r:id="rId5" imgW="3508200" imgH="3587400" progId="Photoshop.Image.18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6980" y="789478"/>
                        <a:ext cx="5021285" cy="5032876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311552" y="134764"/>
            <a:ext cx="2484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5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22316" y="44936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765850" y="45663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19115" y="5951110"/>
            <a:ext cx="116176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ry Figure 5 (A) Expression of circNFATC3 across tissue types (</a:t>
            </a:r>
            <a:r>
              <a:rPr lang="en-US" sz="1200" dirty="0" err="1"/>
              <a:t>circNet</a:t>
            </a:r>
            <a:r>
              <a:rPr lang="en-US" sz="1200" dirty="0"/>
              <a:t> analysis </a:t>
            </a:r>
            <a:r>
              <a:rPr lang="en-US" sz="1200" dirty="0">
                <a:hlinkClick r:id="rId7"/>
              </a:rPr>
              <a:t>http://syslab5.nchu.edu.tw/CircNet/</a:t>
            </a:r>
            <a:r>
              <a:rPr lang="en-US" sz="1200" dirty="0"/>
              <a:t>). (B) Expression of circNFATC3 in cancer and normal cells.</a:t>
            </a:r>
          </a:p>
        </p:txBody>
      </p:sp>
    </p:spTree>
    <p:extLst>
      <p:ext uri="{BB962C8B-B14F-4D97-AF65-F5344CB8AC3E}">
        <p14:creationId xmlns:p14="http://schemas.microsoft.com/office/powerpoint/2010/main" val="1690902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</TotalTime>
  <Words>1046</Words>
  <Application>Microsoft Office PowerPoint</Application>
  <PresentationFormat>Widescreen</PresentationFormat>
  <Paragraphs>168</Paragraphs>
  <Slides>13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sni aziz</dc:creator>
  <cp:lastModifiedBy>thasni aziz</cp:lastModifiedBy>
  <cp:revision>92</cp:revision>
  <dcterms:created xsi:type="dcterms:W3CDTF">2019-07-03T17:24:30Z</dcterms:created>
  <dcterms:modified xsi:type="dcterms:W3CDTF">2021-02-19T07:43:47Z</dcterms:modified>
</cp:coreProperties>
</file>